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82" r:id="rId3"/>
    <p:sldId id="286" r:id="rId4"/>
    <p:sldId id="287" r:id="rId5"/>
    <p:sldId id="277" r:id="rId6"/>
    <p:sldId id="281" r:id="rId7"/>
    <p:sldId id="284" r:id="rId8"/>
    <p:sldId id="285" r:id="rId9"/>
    <p:sldId id="278" r:id="rId10"/>
    <p:sldId id="283" r:id="rId11"/>
    <p:sldId id="288" r:id="rId12"/>
    <p:sldId id="289" r:id="rId13"/>
    <p:sldId id="259" r:id="rId14"/>
    <p:sldId id="290" r:id="rId15"/>
    <p:sldId id="279" r:id="rId16"/>
    <p:sldId id="291" r:id="rId17"/>
    <p:sldId id="292" r:id="rId18"/>
    <p:sldId id="293" r:id="rId19"/>
    <p:sldId id="280" r:id="rId20"/>
    <p:sldId id="294" r:id="rId21"/>
    <p:sldId id="295" r:id="rId22"/>
    <p:sldId id="296" r:id="rId2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BB6FDE-ED65-4243-A88C-742FC9B8C3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B36CFA2-1E3F-4A63-8123-3939A62C1F3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12AAB2-8B1D-451B-98A7-99316A3050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D1BDE-410C-4EF7-83EC-40E16400E86D}" type="datetimeFigureOut">
              <a:rPr lang="zh-CN" altLang="en-US" smtClean="0"/>
              <a:t>2022/9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E1678B5-4AB8-43D9-91A8-9150ADB46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43F5E58-7537-4E64-8747-6E1DAD21F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DA20A-C91A-42A4-A343-916C3603E5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0657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AFAC02-E04C-4410-AC81-F76CE72542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5687C27-D36E-4E2E-A7E5-B6FAF852EA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1E117A8-4234-452E-A63D-EA27E7FDC3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D1BDE-410C-4EF7-83EC-40E16400E86D}" type="datetimeFigureOut">
              <a:rPr lang="zh-CN" altLang="en-US" smtClean="0"/>
              <a:t>2022/9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D3EFBB3-F47C-45C2-B6F5-B0444431A7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CCD8879-7E75-4C1A-8566-3088959FF0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DA20A-C91A-42A4-A343-916C3603E5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7541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F374AC5-25A2-4229-978A-288C9E45A7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642C41B-EC60-4158-B22B-63A5D84E6A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A83C363-7C96-44B3-B354-BCAB5FCC97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D1BDE-410C-4EF7-83EC-40E16400E86D}" type="datetimeFigureOut">
              <a:rPr lang="zh-CN" altLang="en-US" smtClean="0"/>
              <a:t>2022/9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F3A1665-A82B-4FC0-9668-4BA2398C36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5DA93D5-BD0C-46C2-8973-004235EEA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DA20A-C91A-42A4-A343-916C3603E5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51087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D17BD0-590A-498B-B349-FDC518A4E6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0A3EC6F-F5EA-471D-81F3-D6DA0D3801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469E51-1A09-43C5-A9AA-25373A11B8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D1BDE-410C-4EF7-83EC-40E16400E86D}" type="datetimeFigureOut">
              <a:rPr lang="zh-CN" altLang="en-US" smtClean="0"/>
              <a:t>2022/9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8B878F-0AEE-4AAE-9217-0B65A20BF4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F38446F-E8E0-4308-952F-18E9711C3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DA20A-C91A-42A4-A343-916C3603E5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5223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0A33F1-9470-45ED-9D1E-9340D930FB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E01A7C1-10F8-403E-8D9E-774EDC7EA9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82B284A-0ABC-4A3E-84C8-23EF843670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D1BDE-410C-4EF7-83EC-40E16400E86D}" type="datetimeFigureOut">
              <a:rPr lang="zh-CN" altLang="en-US" smtClean="0"/>
              <a:t>2022/9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9E7B0C-C7DD-4429-A565-268047D942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B3CAF02-7E4D-43EA-AA13-B14120A075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DA20A-C91A-42A4-A343-916C3603E5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347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A48FFE-E1CF-47D0-8BE2-FA5B389ECE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7DE60EE-E171-4A93-84CD-D9ABA41849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2CFAD0D-9071-4008-B1D9-5975C545F6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C431046-4FE4-41AC-8F89-DFACA9F075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D1BDE-410C-4EF7-83EC-40E16400E86D}" type="datetimeFigureOut">
              <a:rPr lang="zh-CN" altLang="en-US" smtClean="0"/>
              <a:t>2022/9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BF22C32-3B02-4721-BAAB-3864EB7CAB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70DBC6-1283-4C9D-8AAA-C1C0608ADE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DA20A-C91A-42A4-A343-916C3603E5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07600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FF65E62-655F-4B38-BB8A-B01EA0871C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95058CC-72C0-4E23-84EC-0E13817A69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001FF86-7FC4-4D34-A112-AB562CCF3F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8AFF36A-4C2E-48CA-A756-8177E37DF52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6645217-7D74-45BC-9C26-A52674ADE1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39232CD-5560-40B6-9BA9-644CDE732E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D1BDE-410C-4EF7-83EC-40E16400E86D}" type="datetimeFigureOut">
              <a:rPr lang="zh-CN" altLang="en-US" smtClean="0"/>
              <a:t>2022/9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F208CB4-899A-4480-8121-68482DDA3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308DF8E-A998-41CD-A14B-712D5BF1C5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DA20A-C91A-42A4-A343-916C3603E5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1189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26B9BD2-3DBB-4D77-ADFF-2B41D0BEA0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3F9A045-9B77-42E4-9740-8D9398B164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D1BDE-410C-4EF7-83EC-40E16400E86D}" type="datetimeFigureOut">
              <a:rPr lang="zh-CN" altLang="en-US" smtClean="0"/>
              <a:t>2022/9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A31A5C5-456A-44B6-9602-26732F8D6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0F8562B-C90C-49D3-A39C-82EC69761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DA20A-C91A-42A4-A343-916C3603E5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8935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232BE49-6857-4D54-8370-66A9F1F06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D1BDE-410C-4EF7-83EC-40E16400E86D}" type="datetimeFigureOut">
              <a:rPr lang="zh-CN" altLang="en-US" smtClean="0"/>
              <a:t>2022/9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F39093E-BE39-4DB0-BB31-C69D160890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BAFB867-23E0-4E77-9364-16CE4C0BEA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DA20A-C91A-42A4-A343-916C3603E5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5146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FFE2A81-C28C-4393-B84C-9A871DDD50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0D6F6CA-679D-4A6C-8DF5-EDA120E4DF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0EBE78A-09F3-422A-B7E3-B3319E0652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42BDECD-B30E-408A-8998-4C7DC81AF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D1BDE-410C-4EF7-83EC-40E16400E86D}" type="datetimeFigureOut">
              <a:rPr lang="zh-CN" altLang="en-US" smtClean="0"/>
              <a:t>2022/9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BEBAF37-7465-4C87-AC0B-3ADD675EFA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96980DE-57FB-425A-9FDC-47A8311B77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DA20A-C91A-42A4-A343-916C3603E5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8158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2A5FE3-BD29-4920-9405-99703E10D5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4A25AA0-77D7-492C-AABF-88D9E1D3105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473E04B-5B3F-408D-8DC1-F6A3BF8F32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56013CF-2346-4A56-8954-E92A6340B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D1BDE-410C-4EF7-83EC-40E16400E86D}" type="datetimeFigureOut">
              <a:rPr lang="zh-CN" altLang="en-US" smtClean="0"/>
              <a:t>2022/9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063D3D4-DA9B-4359-91A5-2280B96D3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41473BF-EBBF-4E89-B14C-6654B33CF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DA20A-C91A-42A4-A343-916C3603E5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86316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1B69D48-19B3-4EE5-BB70-FE20131E2C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0F42841-9AF8-4E5C-81D4-33D1C3C227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D387DB0-7067-416C-A616-976883C4128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0D1BDE-410C-4EF7-83EC-40E16400E86D}" type="datetimeFigureOut">
              <a:rPr lang="zh-CN" altLang="en-US" smtClean="0"/>
              <a:t>2022/9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23709E4-73DD-4698-9231-6A00F45F36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02188F1-A9D5-48AA-A8D2-9965F5DDF9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2DA20A-C91A-42A4-A343-916C3603E5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6726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6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9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2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7" Type="http://schemas.openxmlformats.org/officeDocument/2006/relationships/image" Target="../media/image48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7.png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7" Type="http://schemas.openxmlformats.org/officeDocument/2006/relationships/image" Target="../media/image56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5.png"/><Relationship Id="rId5" Type="http://schemas.openxmlformats.org/officeDocument/2006/relationships/image" Target="../media/image54.png"/><Relationship Id="rId4" Type="http://schemas.openxmlformats.org/officeDocument/2006/relationships/image" Target="../media/image53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8.png"/><Relationship Id="rId3" Type="http://schemas.openxmlformats.org/officeDocument/2006/relationships/image" Target="../media/image63.png"/><Relationship Id="rId7" Type="http://schemas.openxmlformats.org/officeDocument/2006/relationships/image" Target="../media/image67.png"/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6.png"/><Relationship Id="rId5" Type="http://schemas.openxmlformats.org/officeDocument/2006/relationships/image" Target="../media/image65.png"/><Relationship Id="rId10" Type="http://schemas.openxmlformats.org/officeDocument/2006/relationships/image" Target="../media/image70.png"/><Relationship Id="rId4" Type="http://schemas.openxmlformats.org/officeDocument/2006/relationships/image" Target="../media/image64.png"/><Relationship Id="rId9" Type="http://schemas.openxmlformats.org/officeDocument/2006/relationships/image" Target="../media/image69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2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png"/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png"/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10" Type="http://schemas.openxmlformats.org/officeDocument/2006/relationships/image" Target="../media/image33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图片 38">
            <a:extLst>
              <a:ext uri="{FF2B5EF4-FFF2-40B4-BE49-F238E27FC236}">
                <a16:creationId xmlns:a16="http://schemas.microsoft.com/office/drawing/2014/main" id="{F1F35984-4303-9349-B31D-845DF9A1FA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89946" y="2681186"/>
            <a:ext cx="3906755" cy="1021947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0846832C-E0A1-6D2F-6D39-8FCD921054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08224" y="2557395"/>
            <a:ext cx="4448776" cy="142261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767B9B53-620C-42EB-A6EB-B9312AF0185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33375">
            <a:off x="1225050" y="2968516"/>
            <a:ext cx="3861382" cy="593416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0AF3AA4-ACC9-439B-B8F0-A36CC7E1C349}"/>
              </a:ext>
            </a:extLst>
          </p:cNvPr>
          <p:cNvSpPr txBox="1"/>
          <p:nvPr/>
        </p:nvSpPr>
        <p:spPr>
          <a:xfrm>
            <a:off x="323748" y="303194"/>
            <a:ext cx="3281604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3D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opped membrane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7311EEC1-7EFA-41D2-91D2-923C67B7C32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1046" t="31158" r="11211" b="36709"/>
          <a:stretch/>
        </p:blipFill>
        <p:spPr>
          <a:xfrm>
            <a:off x="1508172" y="2067944"/>
            <a:ext cx="3179899" cy="391677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64A78E6E-AF1B-4676-A8A0-0584A19DBC77}"/>
              </a:ext>
            </a:extLst>
          </p:cNvPr>
          <p:cNvSpPr txBox="1"/>
          <p:nvPr/>
        </p:nvSpPr>
        <p:spPr>
          <a:xfrm rot="16200000">
            <a:off x="1171874" y="4385442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4165965F-9F5B-4E78-8FD6-4CFDD73B6C95}"/>
              </a:ext>
            </a:extLst>
          </p:cNvPr>
          <p:cNvSpPr txBox="1"/>
          <p:nvPr/>
        </p:nvSpPr>
        <p:spPr>
          <a:xfrm rot="16200000">
            <a:off x="1639719" y="4385442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Cl</a:t>
            </a:r>
            <a:r>
              <a:rPr lang="en-US" altLang="zh-CN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B130DBB-8C4A-41B4-ADC8-1CDCA7174250}"/>
              </a:ext>
            </a:extLst>
          </p:cNvPr>
          <p:cNvSpPr txBox="1"/>
          <p:nvPr/>
        </p:nvSpPr>
        <p:spPr>
          <a:xfrm rot="16200000">
            <a:off x="2107564" y="4385442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4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39CB76C-097E-4B74-AF1E-AFA8309F5F38}"/>
              </a:ext>
            </a:extLst>
          </p:cNvPr>
          <p:cNvSpPr txBox="1"/>
          <p:nvPr/>
        </p:nvSpPr>
        <p:spPr>
          <a:xfrm rot="16200000">
            <a:off x="2575409" y="4385443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8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FDE0A085-8824-4824-B20A-55DA6282419F}"/>
              </a:ext>
            </a:extLst>
          </p:cNvPr>
          <p:cNvSpPr txBox="1"/>
          <p:nvPr/>
        </p:nvSpPr>
        <p:spPr>
          <a:xfrm rot="16200000">
            <a:off x="2906701" y="4521994"/>
            <a:ext cx="2105567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16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8F25F151-24BE-6BD7-080A-13BE17C603B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5858" b="39165"/>
          <a:stretch/>
        </p:blipFill>
        <p:spPr>
          <a:xfrm>
            <a:off x="4651701" y="2062916"/>
            <a:ext cx="3892743" cy="393682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69BA8EC8-DE56-CF84-35D6-F2EC157F376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89815" y="1709289"/>
            <a:ext cx="3906755" cy="1161468"/>
          </a:xfrm>
          <a:prstGeom prst="rect">
            <a:avLst/>
          </a:prstGeom>
        </p:spPr>
      </p:pic>
      <p:sp>
        <p:nvSpPr>
          <p:cNvPr id="40" name="文本框 39">
            <a:extLst>
              <a:ext uri="{FF2B5EF4-FFF2-40B4-BE49-F238E27FC236}">
                <a16:creationId xmlns:a16="http://schemas.microsoft.com/office/drawing/2014/main" id="{8B2435EB-1B28-2CB4-379E-C5C2FC0B1629}"/>
              </a:ext>
            </a:extLst>
          </p:cNvPr>
          <p:cNvSpPr txBox="1"/>
          <p:nvPr/>
        </p:nvSpPr>
        <p:spPr>
          <a:xfrm rot="16200000">
            <a:off x="4699320" y="4385442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D4A28EC4-1A31-F4CF-EC02-3AD1C0E7B935}"/>
              </a:ext>
            </a:extLst>
          </p:cNvPr>
          <p:cNvSpPr txBox="1"/>
          <p:nvPr/>
        </p:nvSpPr>
        <p:spPr>
          <a:xfrm rot="16200000">
            <a:off x="5167165" y="4385442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Cl</a:t>
            </a:r>
            <a:r>
              <a:rPr lang="en-US" altLang="zh-CN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289DB90E-6729-578D-A2B1-AA302C7CFE73}"/>
              </a:ext>
            </a:extLst>
          </p:cNvPr>
          <p:cNvSpPr txBox="1"/>
          <p:nvPr/>
        </p:nvSpPr>
        <p:spPr>
          <a:xfrm rot="16200000">
            <a:off x="5635010" y="4385442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4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A5D8277D-57B6-AD6C-0136-599D61E32EE9}"/>
              </a:ext>
            </a:extLst>
          </p:cNvPr>
          <p:cNvSpPr txBox="1"/>
          <p:nvPr/>
        </p:nvSpPr>
        <p:spPr>
          <a:xfrm rot="16200000">
            <a:off x="6102855" y="4385443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8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B252AE4A-FA2D-2EDE-AA6D-CE45EE0BA12B}"/>
              </a:ext>
            </a:extLst>
          </p:cNvPr>
          <p:cNvSpPr txBox="1"/>
          <p:nvPr/>
        </p:nvSpPr>
        <p:spPr>
          <a:xfrm rot="16200000">
            <a:off x="6434147" y="4521994"/>
            <a:ext cx="2105567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16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986145AA-B4D5-4A8C-5BCE-F724231CF506}"/>
              </a:ext>
            </a:extLst>
          </p:cNvPr>
          <p:cNvSpPr txBox="1"/>
          <p:nvPr/>
        </p:nvSpPr>
        <p:spPr>
          <a:xfrm rot="16200000">
            <a:off x="8238670" y="4385443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22A3C311-E20C-7FD0-553B-04A1955F16EC}"/>
              </a:ext>
            </a:extLst>
          </p:cNvPr>
          <p:cNvSpPr txBox="1"/>
          <p:nvPr/>
        </p:nvSpPr>
        <p:spPr>
          <a:xfrm rot="16200000">
            <a:off x="8706515" y="4385443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Cl</a:t>
            </a:r>
            <a:r>
              <a:rPr lang="en-US" altLang="zh-CN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8E0D8B2E-D171-4383-6E53-03EE79EF9CDB}"/>
              </a:ext>
            </a:extLst>
          </p:cNvPr>
          <p:cNvSpPr txBox="1"/>
          <p:nvPr/>
        </p:nvSpPr>
        <p:spPr>
          <a:xfrm rot="16200000">
            <a:off x="9174360" y="4385443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4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8906568C-FA0E-D8A7-E33A-E04735205859}"/>
              </a:ext>
            </a:extLst>
          </p:cNvPr>
          <p:cNvSpPr txBox="1"/>
          <p:nvPr/>
        </p:nvSpPr>
        <p:spPr>
          <a:xfrm rot="16200000">
            <a:off x="9642205" y="4385444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8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2B7D0CB8-CB08-B7AE-D4F3-106B19EB49EE}"/>
              </a:ext>
            </a:extLst>
          </p:cNvPr>
          <p:cNvSpPr txBox="1"/>
          <p:nvPr/>
        </p:nvSpPr>
        <p:spPr>
          <a:xfrm rot="16200000">
            <a:off x="9973497" y="4521995"/>
            <a:ext cx="2105567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16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DFC636D-D527-ABA2-9292-075A29D90FA8}"/>
              </a:ext>
            </a:extLst>
          </p:cNvPr>
          <p:cNvSpPr txBox="1"/>
          <p:nvPr/>
        </p:nvSpPr>
        <p:spPr>
          <a:xfrm>
            <a:off x="2710950" y="1471999"/>
            <a:ext cx="6238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1st</a:t>
            </a:r>
            <a:endParaRPr lang="zh-CN" altLang="en-US" sz="2800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055F4C82-ABC6-5EAC-E015-CB7400DECDEF}"/>
              </a:ext>
            </a:extLst>
          </p:cNvPr>
          <p:cNvSpPr txBox="1"/>
          <p:nvPr/>
        </p:nvSpPr>
        <p:spPr>
          <a:xfrm>
            <a:off x="6228031" y="1471999"/>
            <a:ext cx="7649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2nd</a:t>
            </a:r>
            <a:endParaRPr lang="zh-CN" altLang="en-US" sz="2800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23FD2CF8-73B5-86F1-8669-BA2724060D93}"/>
              </a:ext>
            </a:extLst>
          </p:cNvPr>
          <p:cNvSpPr txBox="1"/>
          <p:nvPr/>
        </p:nvSpPr>
        <p:spPr>
          <a:xfrm>
            <a:off x="9831752" y="1471999"/>
            <a:ext cx="7232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3rd</a:t>
            </a:r>
            <a:endParaRPr lang="zh-CN" altLang="en-US" sz="2800" dirty="0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38C82786-FA71-1506-14D7-CBB512C32B7F}"/>
              </a:ext>
            </a:extLst>
          </p:cNvPr>
          <p:cNvSpPr txBox="1"/>
          <p:nvPr/>
        </p:nvSpPr>
        <p:spPr>
          <a:xfrm>
            <a:off x="240481" y="2062916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14E46F75-C842-09E1-ACE7-6C6734FD0526}"/>
              </a:ext>
            </a:extLst>
          </p:cNvPr>
          <p:cNvSpPr txBox="1"/>
          <p:nvPr/>
        </p:nvSpPr>
        <p:spPr>
          <a:xfrm>
            <a:off x="240481" y="3007493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203633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7F5D8D6-A660-4A99-9E20-25A2C28C8E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65778">
            <a:off x="1579629" y="1423800"/>
            <a:ext cx="2482891" cy="3457191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91D169BC-F1EC-CFDA-9672-47E40767ED04}"/>
              </a:ext>
            </a:extLst>
          </p:cNvPr>
          <p:cNvSpPr txBox="1"/>
          <p:nvPr/>
        </p:nvSpPr>
        <p:spPr>
          <a:xfrm>
            <a:off x="323748" y="303194"/>
            <a:ext cx="254909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A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membrane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st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9113798C-7791-E381-1D9A-5668D74A60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96873" y="1440711"/>
            <a:ext cx="2435562" cy="3457191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0AA00ABB-2D75-2094-B092-B4CEFA1FECC2}"/>
              </a:ext>
            </a:extLst>
          </p:cNvPr>
          <p:cNvSpPr txBox="1"/>
          <p:nvPr/>
        </p:nvSpPr>
        <p:spPr>
          <a:xfrm>
            <a:off x="422197" y="2028817"/>
            <a:ext cx="1558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2C02A06-E024-EF32-CF43-FBF78FA79F29}"/>
              </a:ext>
            </a:extLst>
          </p:cNvPr>
          <p:cNvSpPr txBox="1"/>
          <p:nvPr/>
        </p:nvSpPr>
        <p:spPr>
          <a:xfrm>
            <a:off x="3955473" y="2028817"/>
            <a:ext cx="1558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9C29E6F-1FAD-4417-FB2E-0AB7C5628517}"/>
              </a:ext>
            </a:extLst>
          </p:cNvPr>
          <p:cNvSpPr txBox="1"/>
          <p:nvPr/>
        </p:nvSpPr>
        <p:spPr>
          <a:xfrm>
            <a:off x="7685733" y="3337480"/>
            <a:ext cx="1520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33FBE727-5751-47F9-E1A6-F561971398F7}"/>
              </a:ext>
            </a:extLst>
          </p:cNvPr>
          <p:cNvGrpSpPr/>
          <p:nvPr/>
        </p:nvGrpSpPr>
        <p:grpSpPr>
          <a:xfrm>
            <a:off x="5283620" y="4790271"/>
            <a:ext cx="2137367" cy="2105567"/>
            <a:chOff x="5294984" y="3707798"/>
            <a:chExt cx="2137367" cy="2105567"/>
          </a:xfrm>
        </p:grpSpPr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52921DEB-F4D3-A577-CA88-D81A65BD4B38}"/>
                </a:ext>
              </a:extLst>
            </p:cNvPr>
            <p:cNvSpPr txBox="1"/>
            <p:nvPr/>
          </p:nvSpPr>
          <p:spPr>
            <a:xfrm rot="16200000">
              <a:off x="4563418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16A34DE9-D535-56EB-C042-3565856799AF}"/>
                </a:ext>
              </a:extLst>
            </p:cNvPr>
            <p:cNvSpPr txBox="1"/>
            <p:nvPr/>
          </p:nvSpPr>
          <p:spPr>
            <a:xfrm rot="16200000">
              <a:off x="5005427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E2E4ED1F-300B-9B7A-B76A-6D80B73057B3}"/>
                </a:ext>
              </a:extLst>
            </p:cNvPr>
            <p:cNvSpPr txBox="1"/>
            <p:nvPr/>
          </p:nvSpPr>
          <p:spPr>
            <a:xfrm rot="16200000">
              <a:off x="5447436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B2E922EC-F8E6-F614-9788-9E172A452E30}"/>
                </a:ext>
              </a:extLst>
            </p:cNvPr>
            <p:cNvSpPr txBox="1"/>
            <p:nvPr/>
          </p:nvSpPr>
          <p:spPr>
            <a:xfrm rot="16200000">
              <a:off x="5889445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15515DDD-D511-BF50-3539-C1EE4D068406}"/>
                </a:ext>
              </a:extLst>
            </p:cNvPr>
            <p:cNvSpPr txBox="1"/>
            <p:nvPr/>
          </p:nvSpPr>
          <p:spPr>
            <a:xfrm rot="16200000">
              <a:off x="6194901" y="4575916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.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D66137BE-1ED6-178C-2CCF-3F36579C3765}"/>
              </a:ext>
            </a:extLst>
          </p:cNvPr>
          <p:cNvGrpSpPr/>
          <p:nvPr/>
        </p:nvGrpSpPr>
        <p:grpSpPr>
          <a:xfrm>
            <a:off x="9114406" y="4790270"/>
            <a:ext cx="2137367" cy="2105567"/>
            <a:chOff x="5294984" y="3707798"/>
            <a:chExt cx="2137367" cy="2105567"/>
          </a:xfrm>
        </p:grpSpPr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FE72CD71-05A7-29E6-FCE3-3CF4ACFB44CB}"/>
                </a:ext>
              </a:extLst>
            </p:cNvPr>
            <p:cNvSpPr txBox="1"/>
            <p:nvPr/>
          </p:nvSpPr>
          <p:spPr>
            <a:xfrm rot="16200000">
              <a:off x="4563418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D69E24E4-BCCB-661F-84BC-093DD36E386C}"/>
                </a:ext>
              </a:extLst>
            </p:cNvPr>
            <p:cNvSpPr txBox="1"/>
            <p:nvPr/>
          </p:nvSpPr>
          <p:spPr>
            <a:xfrm rot="16200000">
              <a:off x="5005427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E36E0965-AD17-7205-AA11-2BBE23A1CA6D}"/>
                </a:ext>
              </a:extLst>
            </p:cNvPr>
            <p:cNvSpPr txBox="1"/>
            <p:nvPr/>
          </p:nvSpPr>
          <p:spPr>
            <a:xfrm rot="16200000">
              <a:off x="5447436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0060B6A0-0105-418F-5B6B-2B275007D0A3}"/>
                </a:ext>
              </a:extLst>
            </p:cNvPr>
            <p:cNvSpPr txBox="1"/>
            <p:nvPr/>
          </p:nvSpPr>
          <p:spPr>
            <a:xfrm rot="16200000">
              <a:off x="5889445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011AF597-5C39-F0D0-E53C-FC14472E9B18}"/>
                </a:ext>
              </a:extLst>
            </p:cNvPr>
            <p:cNvSpPr txBox="1"/>
            <p:nvPr/>
          </p:nvSpPr>
          <p:spPr>
            <a:xfrm rot="16200000">
              <a:off x="6194901" y="4575916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.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0FEBE188-2768-565A-CC94-A8A1AB00F3D2}"/>
              </a:ext>
            </a:extLst>
          </p:cNvPr>
          <p:cNvGrpSpPr/>
          <p:nvPr/>
        </p:nvGrpSpPr>
        <p:grpSpPr>
          <a:xfrm>
            <a:off x="1762200" y="4790271"/>
            <a:ext cx="2137367" cy="2105567"/>
            <a:chOff x="5294984" y="3707798"/>
            <a:chExt cx="2137367" cy="2105567"/>
          </a:xfrm>
        </p:grpSpPr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40EF07D0-A600-D2B4-9F16-A03303B25855}"/>
                </a:ext>
              </a:extLst>
            </p:cNvPr>
            <p:cNvSpPr txBox="1"/>
            <p:nvPr/>
          </p:nvSpPr>
          <p:spPr>
            <a:xfrm rot="16200000">
              <a:off x="4563418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A7067CD6-C20E-DDC7-FF92-6FC9E2E7A29F}"/>
                </a:ext>
              </a:extLst>
            </p:cNvPr>
            <p:cNvSpPr txBox="1"/>
            <p:nvPr/>
          </p:nvSpPr>
          <p:spPr>
            <a:xfrm rot="16200000">
              <a:off x="5005427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20E11754-FCCD-F685-6C60-DED2AD0C41F9}"/>
                </a:ext>
              </a:extLst>
            </p:cNvPr>
            <p:cNvSpPr txBox="1"/>
            <p:nvPr/>
          </p:nvSpPr>
          <p:spPr>
            <a:xfrm rot="16200000">
              <a:off x="5447436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939C6982-D705-C46F-3DF7-81308789BECF}"/>
                </a:ext>
              </a:extLst>
            </p:cNvPr>
            <p:cNvSpPr txBox="1"/>
            <p:nvPr/>
          </p:nvSpPr>
          <p:spPr>
            <a:xfrm rot="16200000">
              <a:off x="5889445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E56CEBA3-DA85-C41A-0EB2-FBD716F6DC3F}"/>
                </a:ext>
              </a:extLst>
            </p:cNvPr>
            <p:cNvSpPr txBox="1"/>
            <p:nvPr/>
          </p:nvSpPr>
          <p:spPr>
            <a:xfrm rot="16200000">
              <a:off x="6194901" y="4575916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.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4" name="图片 3">
            <a:extLst>
              <a:ext uri="{FF2B5EF4-FFF2-40B4-BE49-F238E27FC236}">
                <a16:creationId xmlns:a16="http://schemas.microsoft.com/office/drawing/2014/main" id="{8272F719-14B0-E8FF-0CF2-B35EE8B2AF8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31848" y="1333080"/>
            <a:ext cx="2558157" cy="34571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363725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701C37B-F693-4FF7-4B36-AFA2A64F99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91325" y="1588872"/>
            <a:ext cx="2612906" cy="3201398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91D169BC-F1EC-CFDA-9672-47E40767ED04}"/>
              </a:ext>
            </a:extLst>
          </p:cNvPr>
          <p:cNvSpPr txBox="1"/>
          <p:nvPr/>
        </p:nvSpPr>
        <p:spPr>
          <a:xfrm>
            <a:off x="323748" y="303194"/>
            <a:ext cx="254909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A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membrane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nd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233CC77-ED57-367D-3A14-384DEBE4E2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71018" y="1588872"/>
            <a:ext cx="2447690" cy="320139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EF5EF8A-9A83-F689-F2FF-605B2D7EC9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64380">
            <a:off x="4756703" y="1304795"/>
            <a:ext cx="2858701" cy="3971321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954DFE0A-413B-CD48-7D9A-6F074148CFF5}"/>
              </a:ext>
            </a:extLst>
          </p:cNvPr>
          <p:cNvSpPr txBox="1"/>
          <p:nvPr/>
        </p:nvSpPr>
        <p:spPr>
          <a:xfrm>
            <a:off x="422197" y="2028817"/>
            <a:ext cx="1558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E95BECA-7267-C12E-7CBD-8A7B1054CEBC}"/>
              </a:ext>
            </a:extLst>
          </p:cNvPr>
          <p:cNvSpPr txBox="1"/>
          <p:nvPr/>
        </p:nvSpPr>
        <p:spPr>
          <a:xfrm>
            <a:off x="3955473" y="2028817"/>
            <a:ext cx="1558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0F88E52-DF83-2AB2-B8C5-76358D2FECA8}"/>
              </a:ext>
            </a:extLst>
          </p:cNvPr>
          <p:cNvSpPr txBox="1"/>
          <p:nvPr/>
        </p:nvSpPr>
        <p:spPr>
          <a:xfrm>
            <a:off x="7533333" y="3496807"/>
            <a:ext cx="1520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E07CB52B-6258-BDB9-99B9-875B53697285}"/>
              </a:ext>
            </a:extLst>
          </p:cNvPr>
          <p:cNvGrpSpPr/>
          <p:nvPr/>
        </p:nvGrpSpPr>
        <p:grpSpPr>
          <a:xfrm>
            <a:off x="5117369" y="4790271"/>
            <a:ext cx="2137367" cy="2105567"/>
            <a:chOff x="5294984" y="3707798"/>
            <a:chExt cx="2137367" cy="2105567"/>
          </a:xfrm>
        </p:grpSpPr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6F9491EE-DA5E-2167-84AE-A0EF1B72A44E}"/>
                </a:ext>
              </a:extLst>
            </p:cNvPr>
            <p:cNvSpPr txBox="1"/>
            <p:nvPr/>
          </p:nvSpPr>
          <p:spPr>
            <a:xfrm rot="16200000">
              <a:off x="4563418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E861E3E7-B9E5-A2B3-6A24-927CE3D03BD3}"/>
                </a:ext>
              </a:extLst>
            </p:cNvPr>
            <p:cNvSpPr txBox="1"/>
            <p:nvPr/>
          </p:nvSpPr>
          <p:spPr>
            <a:xfrm rot="16200000">
              <a:off x="5005427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E0F8E80D-A2A7-1F67-0D08-07ECFC1D0727}"/>
                </a:ext>
              </a:extLst>
            </p:cNvPr>
            <p:cNvSpPr txBox="1"/>
            <p:nvPr/>
          </p:nvSpPr>
          <p:spPr>
            <a:xfrm rot="16200000">
              <a:off x="5447436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2DD8DA23-A285-9E91-91AF-5DE65902F224}"/>
                </a:ext>
              </a:extLst>
            </p:cNvPr>
            <p:cNvSpPr txBox="1"/>
            <p:nvPr/>
          </p:nvSpPr>
          <p:spPr>
            <a:xfrm rot="16200000">
              <a:off x="5889445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F877A42A-6693-E875-5D14-537C26B81927}"/>
                </a:ext>
              </a:extLst>
            </p:cNvPr>
            <p:cNvSpPr txBox="1"/>
            <p:nvPr/>
          </p:nvSpPr>
          <p:spPr>
            <a:xfrm rot="16200000">
              <a:off x="6194901" y="4575916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.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" name="组合 18">
            <a:extLst>
              <a:ext uri="{FF2B5EF4-FFF2-40B4-BE49-F238E27FC236}">
                <a16:creationId xmlns:a16="http://schemas.microsoft.com/office/drawing/2014/main" id="{48A65824-E6EF-8D37-64F4-3653904F74FD}"/>
              </a:ext>
            </a:extLst>
          </p:cNvPr>
          <p:cNvGrpSpPr/>
          <p:nvPr/>
        </p:nvGrpSpPr>
        <p:grpSpPr>
          <a:xfrm>
            <a:off x="1926179" y="4790272"/>
            <a:ext cx="2137367" cy="2105567"/>
            <a:chOff x="5294984" y="3707798"/>
            <a:chExt cx="2137367" cy="2105567"/>
          </a:xfrm>
        </p:grpSpPr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6F8CC9C7-9C5F-FCD6-C1DC-7907EE16356E}"/>
                </a:ext>
              </a:extLst>
            </p:cNvPr>
            <p:cNvSpPr txBox="1"/>
            <p:nvPr/>
          </p:nvSpPr>
          <p:spPr>
            <a:xfrm rot="16200000">
              <a:off x="4563418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5A819211-F4A3-50D1-024E-6D2C75005726}"/>
                </a:ext>
              </a:extLst>
            </p:cNvPr>
            <p:cNvSpPr txBox="1"/>
            <p:nvPr/>
          </p:nvSpPr>
          <p:spPr>
            <a:xfrm rot="16200000">
              <a:off x="5005427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7E853CBA-DDC2-BB46-C087-E4961A5B8F14}"/>
                </a:ext>
              </a:extLst>
            </p:cNvPr>
            <p:cNvSpPr txBox="1"/>
            <p:nvPr/>
          </p:nvSpPr>
          <p:spPr>
            <a:xfrm rot="16200000">
              <a:off x="5447436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379FF84B-7AC5-8AB0-0979-59029B93218E}"/>
                </a:ext>
              </a:extLst>
            </p:cNvPr>
            <p:cNvSpPr txBox="1"/>
            <p:nvPr/>
          </p:nvSpPr>
          <p:spPr>
            <a:xfrm rot="16200000">
              <a:off x="5889445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68FCB1E9-3D10-CF09-AC28-0CDAC7648E55}"/>
                </a:ext>
              </a:extLst>
            </p:cNvPr>
            <p:cNvSpPr txBox="1"/>
            <p:nvPr/>
          </p:nvSpPr>
          <p:spPr>
            <a:xfrm rot="16200000">
              <a:off x="6194901" y="4575916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.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" name="组合 24">
            <a:extLst>
              <a:ext uri="{FF2B5EF4-FFF2-40B4-BE49-F238E27FC236}">
                <a16:creationId xmlns:a16="http://schemas.microsoft.com/office/drawing/2014/main" id="{80AFF748-A8CE-A802-4005-408FE6B81C33}"/>
              </a:ext>
            </a:extLst>
          </p:cNvPr>
          <p:cNvGrpSpPr/>
          <p:nvPr/>
        </p:nvGrpSpPr>
        <p:grpSpPr>
          <a:xfrm>
            <a:off x="8927369" y="4790271"/>
            <a:ext cx="2137367" cy="2105567"/>
            <a:chOff x="5294984" y="3707798"/>
            <a:chExt cx="2137367" cy="2105567"/>
          </a:xfrm>
        </p:grpSpPr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2FCE948C-873A-DC5B-4970-B3F8EFEC975F}"/>
                </a:ext>
              </a:extLst>
            </p:cNvPr>
            <p:cNvSpPr txBox="1"/>
            <p:nvPr/>
          </p:nvSpPr>
          <p:spPr>
            <a:xfrm rot="16200000">
              <a:off x="4563418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3F2E3806-BE41-7826-723B-56548BAE5856}"/>
                </a:ext>
              </a:extLst>
            </p:cNvPr>
            <p:cNvSpPr txBox="1"/>
            <p:nvPr/>
          </p:nvSpPr>
          <p:spPr>
            <a:xfrm rot="16200000">
              <a:off x="5005427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6D3A7AF5-5CC6-7573-0263-6FFDCE5365C9}"/>
                </a:ext>
              </a:extLst>
            </p:cNvPr>
            <p:cNvSpPr txBox="1"/>
            <p:nvPr/>
          </p:nvSpPr>
          <p:spPr>
            <a:xfrm rot="16200000">
              <a:off x="5447436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02F89F8C-96B2-34DD-AE32-4B0F39615EC7}"/>
                </a:ext>
              </a:extLst>
            </p:cNvPr>
            <p:cNvSpPr txBox="1"/>
            <p:nvPr/>
          </p:nvSpPr>
          <p:spPr>
            <a:xfrm rot="16200000">
              <a:off x="5889445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60E7F0DE-73DE-910E-E8A9-9C4A92A036AD}"/>
                </a:ext>
              </a:extLst>
            </p:cNvPr>
            <p:cNvSpPr txBox="1"/>
            <p:nvPr/>
          </p:nvSpPr>
          <p:spPr>
            <a:xfrm rot="16200000">
              <a:off x="6194901" y="4575916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.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176266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0AC9074-E10A-529E-3329-4D21A439E4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24250" y="1688189"/>
            <a:ext cx="2459520" cy="3166833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91D169BC-F1EC-CFDA-9672-47E40767ED04}"/>
              </a:ext>
            </a:extLst>
          </p:cNvPr>
          <p:cNvSpPr txBox="1"/>
          <p:nvPr/>
        </p:nvSpPr>
        <p:spPr>
          <a:xfrm>
            <a:off x="323748" y="303194"/>
            <a:ext cx="254909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A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membrane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rd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539894C-5E72-9698-8F60-2F51E3BDEEE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436048">
            <a:off x="1677116" y="1538646"/>
            <a:ext cx="2692171" cy="337086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8D6EC6AB-75B5-24C8-F66A-E82288C577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52130" y="1578486"/>
            <a:ext cx="2663589" cy="3937836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511D4D5B-D04E-0A5F-1C4B-03196C7E2545}"/>
              </a:ext>
            </a:extLst>
          </p:cNvPr>
          <p:cNvSpPr txBox="1"/>
          <p:nvPr/>
        </p:nvSpPr>
        <p:spPr>
          <a:xfrm>
            <a:off x="422197" y="2028817"/>
            <a:ext cx="1558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9DA1AC1-91B1-F79D-79F9-9FAAC66E6832}"/>
              </a:ext>
            </a:extLst>
          </p:cNvPr>
          <p:cNvSpPr txBox="1"/>
          <p:nvPr/>
        </p:nvSpPr>
        <p:spPr>
          <a:xfrm>
            <a:off x="3955473" y="2028817"/>
            <a:ext cx="1558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C3232B9-C145-10D7-72DE-42589F881BE2}"/>
              </a:ext>
            </a:extLst>
          </p:cNvPr>
          <p:cNvSpPr txBox="1"/>
          <p:nvPr/>
        </p:nvSpPr>
        <p:spPr>
          <a:xfrm>
            <a:off x="7533333" y="3496807"/>
            <a:ext cx="1520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396F154E-4941-0A6F-5C12-EB8D54057AA4}"/>
              </a:ext>
            </a:extLst>
          </p:cNvPr>
          <p:cNvGrpSpPr/>
          <p:nvPr/>
        </p:nvGrpSpPr>
        <p:grpSpPr>
          <a:xfrm>
            <a:off x="1980433" y="4852617"/>
            <a:ext cx="2137367" cy="2105567"/>
            <a:chOff x="5294984" y="3707798"/>
            <a:chExt cx="2137367" cy="2105567"/>
          </a:xfrm>
        </p:grpSpPr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503D331D-AE29-6185-CA27-2156636F5D64}"/>
                </a:ext>
              </a:extLst>
            </p:cNvPr>
            <p:cNvSpPr txBox="1"/>
            <p:nvPr/>
          </p:nvSpPr>
          <p:spPr>
            <a:xfrm rot="16200000">
              <a:off x="4563418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4FF14607-6F4D-677B-559A-7FFB3A553942}"/>
                </a:ext>
              </a:extLst>
            </p:cNvPr>
            <p:cNvSpPr txBox="1"/>
            <p:nvPr/>
          </p:nvSpPr>
          <p:spPr>
            <a:xfrm rot="16200000">
              <a:off x="5005427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8D8A431C-3794-F1AE-EF64-FF320C479AD5}"/>
                </a:ext>
              </a:extLst>
            </p:cNvPr>
            <p:cNvSpPr txBox="1"/>
            <p:nvPr/>
          </p:nvSpPr>
          <p:spPr>
            <a:xfrm rot="16200000">
              <a:off x="5447436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FC599EB0-DBD1-D927-B127-E0D2709F00A9}"/>
                </a:ext>
              </a:extLst>
            </p:cNvPr>
            <p:cNvSpPr txBox="1"/>
            <p:nvPr/>
          </p:nvSpPr>
          <p:spPr>
            <a:xfrm rot="16200000">
              <a:off x="5889445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699980EC-DE21-7526-81AD-8A500E105235}"/>
                </a:ext>
              </a:extLst>
            </p:cNvPr>
            <p:cNvSpPr txBox="1"/>
            <p:nvPr/>
          </p:nvSpPr>
          <p:spPr>
            <a:xfrm rot="16200000">
              <a:off x="6194901" y="4575916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.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8E83214C-C3FD-1B05-922D-3697970AE87B}"/>
              </a:ext>
            </a:extLst>
          </p:cNvPr>
          <p:cNvGrpSpPr/>
          <p:nvPr/>
        </p:nvGrpSpPr>
        <p:grpSpPr>
          <a:xfrm>
            <a:off x="5395966" y="4852616"/>
            <a:ext cx="2137367" cy="2105567"/>
            <a:chOff x="5294984" y="3707798"/>
            <a:chExt cx="2137367" cy="2105567"/>
          </a:xfrm>
        </p:grpSpPr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1ACB8E00-887E-9594-708C-1F66DF519E98}"/>
                </a:ext>
              </a:extLst>
            </p:cNvPr>
            <p:cNvSpPr txBox="1"/>
            <p:nvPr/>
          </p:nvSpPr>
          <p:spPr>
            <a:xfrm rot="16200000">
              <a:off x="4563418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AC553874-2D5C-334C-2372-59543CCBAE5D}"/>
                </a:ext>
              </a:extLst>
            </p:cNvPr>
            <p:cNvSpPr txBox="1"/>
            <p:nvPr/>
          </p:nvSpPr>
          <p:spPr>
            <a:xfrm rot="16200000">
              <a:off x="5005427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F125B7C7-E778-6322-CBDE-15B88751B3F7}"/>
                </a:ext>
              </a:extLst>
            </p:cNvPr>
            <p:cNvSpPr txBox="1"/>
            <p:nvPr/>
          </p:nvSpPr>
          <p:spPr>
            <a:xfrm rot="16200000">
              <a:off x="5447436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E41FEDE2-3C3C-4B6F-1626-59D047D18F5C}"/>
                </a:ext>
              </a:extLst>
            </p:cNvPr>
            <p:cNvSpPr txBox="1"/>
            <p:nvPr/>
          </p:nvSpPr>
          <p:spPr>
            <a:xfrm rot="16200000">
              <a:off x="5889445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32B0C62F-FAB1-33B7-0D7F-E01EE7EABC34}"/>
                </a:ext>
              </a:extLst>
            </p:cNvPr>
            <p:cNvSpPr txBox="1"/>
            <p:nvPr/>
          </p:nvSpPr>
          <p:spPr>
            <a:xfrm rot="16200000">
              <a:off x="6194901" y="4575916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.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95A23C51-7223-9048-1D54-096B0385A072}"/>
              </a:ext>
            </a:extLst>
          </p:cNvPr>
          <p:cNvGrpSpPr/>
          <p:nvPr/>
        </p:nvGrpSpPr>
        <p:grpSpPr>
          <a:xfrm>
            <a:off x="8932035" y="4852617"/>
            <a:ext cx="2137367" cy="2105567"/>
            <a:chOff x="5294984" y="3707798"/>
            <a:chExt cx="2137367" cy="2105567"/>
          </a:xfrm>
        </p:grpSpPr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5EC14834-0579-E1A0-4ED9-B7345BB1A948}"/>
                </a:ext>
              </a:extLst>
            </p:cNvPr>
            <p:cNvSpPr txBox="1"/>
            <p:nvPr/>
          </p:nvSpPr>
          <p:spPr>
            <a:xfrm rot="16200000">
              <a:off x="4563418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1D770F81-0A6A-AC96-950D-45283F333D60}"/>
                </a:ext>
              </a:extLst>
            </p:cNvPr>
            <p:cNvSpPr txBox="1"/>
            <p:nvPr/>
          </p:nvSpPr>
          <p:spPr>
            <a:xfrm rot="16200000">
              <a:off x="5005427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F1F975ED-5969-8C66-33F8-0555E629B0CC}"/>
                </a:ext>
              </a:extLst>
            </p:cNvPr>
            <p:cNvSpPr txBox="1"/>
            <p:nvPr/>
          </p:nvSpPr>
          <p:spPr>
            <a:xfrm rot="16200000">
              <a:off x="5447436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F6A123AE-9E0C-9A38-ACA9-094B8C565878}"/>
                </a:ext>
              </a:extLst>
            </p:cNvPr>
            <p:cNvSpPr txBox="1"/>
            <p:nvPr/>
          </p:nvSpPr>
          <p:spPr>
            <a:xfrm rot="16200000">
              <a:off x="5889445" y="4439364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E41F23A8-DBEB-37B3-7376-7E8D176569B8}"/>
                </a:ext>
              </a:extLst>
            </p:cNvPr>
            <p:cNvSpPr txBox="1"/>
            <p:nvPr/>
          </p:nvSpPr>
          <p:spPr>
            <a:xfrm rot="16200000">
              <a:off x="6194901" y="4575916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.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5091794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40">
            <a:extLst>
              <a:ext uri="{FF2B5EF4-FFF2-40B4-BE49-F238E27FC236}">
                <a16:creationId xmlns:a16="http://schemas.microsoft.com/office/drawing/2014/main" id="{B3C3ABC8-206F-AEC1-2B28-08DBAF1033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14366" y="2212140"/>
            <a:ext cx="2490183" cy="1124356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AC641A93-DBCB-46A9-8053-652128343F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9630" y="2956707"/>
            <a:ext cx="2889461" cy="1471556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F8F7DFAD-3650-43FE-BA22-84DBA95EC3D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460" t="19601" r="14831" b="35507"/>
          <a:stretch/>
        </p:blipFill>
        <p:spPr>
          <a:xfrm>
            <a:off x="1369433" y="2462356"/>
            <a:ext cx="2572130" cy="62392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0AF3AA4-ACC9-439B-B8F0-A36CC7E1C349}"/>
              </a:ext>
            </a:extLst>
          </p:cNvPr>
          <p:cNvSpPr txBox="1"/>
          <p:nvPr/>
        </p:nvSpPr>
        <p:spPr>
          <a:xfrm>
            <a:off x="625764" y="447964"/>
            <a:ext cx="3281604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FIG.6A</a:t>
            </a:r>
          </a:p>
          <a:p>
            <a:r>
              <a:rPr lang="en-US" altLang="zh-CN" dirty="0"/>
              <a:t>Cropped membrane</a:t>
            </a:r>
            <a:endParaRPr lang="zh-CN" altLang="en-US" dirty="0"/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6ABC2039-C192-42FE-952D-A8B4E2EE6610}"/>
              </a:ext>
            </a:extLst>
          </p:cNvPr>
          <p:cNvGrpSpPr/>
          <p:nvPr/>
        </p:nvGrpSpPr>
        <p:grpSpPr>
          <a:xfrm>
            <a:off x="378731" y="2567824"/>
            <a:ext cx="1852686" cy="1279730"/>
            <a:chOff x="3394435" y="2738919"/>
            <a:chExt cx="578663" cy="477956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F177F6B1-6D25-426F-8D03-4CED4E75380D}"/>
                </a:ext>
              </a:extLst>
            </p:cNvPr>
            <p:cNvSpPr txBox="1"/>
            <p:nvPr/>
          </p:nvSpPr>
          <p:spPr>
            <a:xfrm>
              <a:off x="3400751" y="2738919"/>
              <a:ext cx="572347" cy="1379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STAT3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C02D60A1-4313-4C46-9727-032DA992B0CE}"/>
                </a:ext>
              </a:extLst>
            </p:cNvPr>
            <p:cNvSpPr txBox="1"/>
            <p:nvPr/>
          </p:nvSpPr>
          <p:spPr>
            <a:xfrm>
              <a:off x="3394435" y="3078936"/>
              <a:ext cx="572347" cy="1379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" name="文本框 6">
            <a:extLst>
              <a:ext uri="{FF2B5EF4-FFF2-40B4-BE49-F238E27FC236}">
                <a16:creationId xmlns:a16="http://schemas.microsoft.com/office/drawing/2014/main" id="{7F90711A-8238-478E-A288-E78847E05990}"/>
              </a:ext>
            </a:extLst>
          </p:cNvPr>
          <p:cNvSpPr txBox="1"/>
          <p:nvPr/>
        </p:nvSpPr>
        <p:spPr>
          <a:xfrm>
            <a:off x="2231416" y="4146581"/>
            <a:ext cx="1832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FDF127D-88A3-49CE-BAF8-DE264CFFA6C6}"/>
              </a:ext>
            </a:extLst>
          </p:cNvPr>
          <p:cNvSpPr txBox="1"/>
          <p:nvPr/>
        </p:nvSpPr>
        <p:spPr>
          <a:xfrm>
            <a:off x="1456424" y="4146581"/>
            <a:ext cx="1832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050285F-2803-014F-127E-8CA37A7BD610}"/>
              </a:ext>
            </a:extLst>
          </p:cNvPr>
          <p:cNvSpPr txBox="1"/>
          <p:nvPr/>
        </p:nvSpPr>
        <p:spPr>
          <a:xfrm>
            <a:off x="2365310" y="1852416"/>
            <a:ext cx="6238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1st</a:t>
            </a:r>
            <a:endParaRPr lang="zh-CN" altLang="en-US" sz="2800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FE05A69F-F78F-F6C5-7A9E-CF9ECA947D56}"/>
              </a:ext>
            </a:extLst>
          </p:cNvPr>
          <p:cNvSpPr txBox="1"/>
          <p:nvPr/>
        </p:nvSpPr>
        <p:spPr>
          <a:xfrm>
            <a:off x="5777759" y="1852416"/>
            <a:ext cx="7649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2nd</a:t>
            </a:r>
            <a:endParaRPr lang="zh-CN" altLang="en-US" sz="2800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284B431-4A36-42E9-ED48-636D1AAFE3B7}"/>
              </a:ext>
            </a:extLst>
          </p:cNvPr>
          <p:cNvSpPr txBox="1"/>
          <p:nvPr/>
        </p:nvSpPr>
        <p:spPr>
          <a:xfrm>
            <a:off x="9356117" y="1852416"/>
            <a:ext cx="7232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3rd</a:t>
            </a:r>
            <a:endParaRPr lang="zh-CN" altLang="en-US" sz="2800" dirty="0"/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8E50B7D6-C905-030B-2D56-BFBAFAAEB9D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11565" y="3117009"/>
            <a:ext cx="2889461" cy="1091757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6FBB33F9-0642-8E8B-4C12-938D1C68A65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31846" y="3039992"/>
            <a:ext cx="2881162" cy="1124355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3C72B65F-B6D3-27B5-7023-23597E85E03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796540" y="2255496"/>
            <a:ext cx="2744910" cy="1196692"/>
          </a:xfrm>
          <a:prstGeom prst="rect">
            <a:avLst/>
          </a:prstGeom>
        </p:spPr>
      </p:pic>
      <p:sp>
        <p:nvSpPr>
          <p:cNvPr id="43" name="文本框 42">
            <a:extLst>
              <a:ext uri="{FF2B5EF4-FFF2-40B4-BE49-F238E27FC236}">
                <a16:creationId xmlns:a16="http://schemas.microsoft.com/office/drawing/2014/main" id="{A72C45FC-6AA5-7987-5E71-9730D09138A8}"/>
              </a:ext>
            </a:extLst>
          </p:cNvPr>
          <p:cNvSpPr txBox="1"/>
          <p:nvPr/>
        </p:nvSpPr>
        <p:spPr>
          <a:xfrm>
            <a:off x="5469916" y="4164347"/>
            <a:ext cx="1832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5CF2A09E-DC6D-A308-F12F-9554DC9C8E06}"/>
              </a:ext>
            </a:extLst>
          </p:cNvPr>
          <p:cNvSpPr txBox="1"/>
          <p:nvPr/>
        </p:nvSpPr>
        <p:spPr>
          <a:xfrm>
            <a:off x="4694924" y="4164347"/>
            <a:ext cx="1832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923D0892-E54D-E6C0-A943-3310F72A998A}"/>
              </a:ext>
            </a:extLst>
          </p:cNvPr>
          <p:cNvSpPr txBox="1"/>
          <p:nvPr/>
        </p:nvSpPr>
        <p:spPr>
          <a:xfrm>
            <a:off x="9140889" y="4164347"/>
            <a:ext cx="1832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EFEDE5B3-4E3E-7459-069A-FC446FAABE83}"/>
              </a:ext>
            </a:extLst>
          </p:cNvPr>
          <p:cNvSpPr txBox="1"/>
          <p:nvPr/>
        </p:nvSpPr>
        <p:spPr>
          <a:xfrm>
            <a:off x="8365897" y="4164347"/>
            <a:ext cx="1832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09C3D249-B9FE-482B-8123-5ABC965E0105}"/>
              </a:ext>
            </a:extLst>
          </p:cNvPr>
          <p:cNvGrpSpPr/>
          <p:nvPr/>
        </p:nvGrpSpPr>
        <p:grpSpPr>
          <a:xfrm>
            <a:off x="3870197" y="2591945"/>
            <a:ext cx="1852686" cy="1279730"/>
            <a:chOff x="3394435" y="2738919"/>
            <a:chExt cx="578663" cy="477956"/>
          </a:xfrm>
        </p:grpSpPr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321345D3-1E71-4D72-8943-D74E134DBF48}"/>
                </a:ext>
              </a:extLst>
            </p:cNvPr>
            <p:cNvSpPr txBox="1"/>
            <p:nvPr/>
          </p:nvSpPr>
          <p:spPr>
            <a:xfrm>
              <a:off x="3400751" y="2738919"/>
              <a:ext cx="572347" cy="1379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STAT3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E0856A8A-A5A6-468A-9028-4E68E4A0256D}"/>
                </a:ext>
              </a:extLst>
            </p:cNvPr>
            <p:cNvSpPr txBox="1"/>
            <p:nvPr/>
          </p:nvSpPr>
          <p:spPr>
            <a:xfrm>
              <a:off x="3394435" y="3078936"/>
              <a:ext cx="572347" cy="1379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5EF90213-F201-4F72-AC9A-A4C638023718}"/>
              </a:ext>
            </a:extLst>
          </p:cNvPr>
          <p:cNvGrpSpPr/>
          <p:nvPr/>
        </p:nvGrpSpPr>
        <p:grpSpPr>
          <a:xfrm>
            <a:off x="7246913" y="2567824"/>
            <a:ext cx="1852686" cy="1279730"/>
            <a:chOff x="3394435" y="2738919"/>
            <a:chExt cx="578663" cy="477956"/>
          </a:xfrm>
        </p:grpSpPr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DA908E9A-DF38-4437-9026-C243ADA071F8}"/>
                </a:ext>
              </a:extLst>
            </p:cNvPr>
            <p:cNvSpPr txBox="1"/>
            <p:nvPr/>
          </p:nvSpPr>
          <p:spPr>
            <a:xfrm>
              <a:off x="3400751" y="2738919"/>
              <a:ext cx="572347" cy="1379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STAT3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B1AB2A04-423C-4EAF-A676-5068E1D12F7A}"/>
                </a:ext>
              </a:extLst>
            </p:cNvPr>
            <p:cNvSpPr txBox="1"/>
            <p:nvPr/>
          </p:nvSpPr>
          <p:spPr>
            <a:xfrm>
              <a:off x="3394435" y="3078936"/>
              <a:ext cx="572347" cy="1379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4707337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3D7ABBAA-52F0-EA90-1274-C88EC252D6AA}"/>
              </a:ext>
            </a:extLst>
          </p:cNvPr>
          <p:cNvSpPr txBox="1"/>
          <p:nvPr/>
        </p:nvSpPr>
        <p:spPr>
          <a:xfrm>
            <a:off x="625764" y="447964"/>
            <a:ext cx="2638864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FIG.6A</a:t>
            </a:r>
          </a:p>
          <a:p>
            <a:r>
              <a:rPr lang="en-US" altLang="zh-CN" dirty="0"/>
              <a:t>Full membrane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75A1A3D-C3F1-DC18-403B-8DE104429A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3508" y="1987637"/>
            <a:ext cx="4682492" cy="3678527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95BDE818-3CFE-9A40-9A6C-1B8A53646111}"/>
              </a:ext>
            </a:extLst>
          </p:cNvPr>
          <p:cNvSpPr txBox="1"/>
          <p:nvPr/>
        </p:nvSpPr>
        <p:spPr>
          <a:xfrm>
            <a:off x="332509" y="2448511"/>
            <a:ext cx="1558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ACAE5C96-A4E0-BB17-96FB-D1C7069AFF52}"/>
              </a:ext>
            </a:extLst>
          </p:cNvPr>
          <p:cNvSpPr txBox="1"/>
          <p:nvPr/>
        </p:nvSpPr>
        <p:spPr>
          <a:xfrm>
            <a:off x="2042175" y="1450560"/>
            <a:ext cx="6238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1st</a:t>
            </a:r>
            <a:endParaRPr lang="zh-CN" altLang="en-US" sz="28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C639AFC-CD8E-8018-E7D1-5532C92D635E}"/>
              </a:ext>
            </a:extLst>
          </p:cNvPr>
          <p:cNvSpPr txBox="1"/>
          <p:nvPr/>
        </p:nvSpPr>
        <p:spPr>
          <a:xfrm>
            <a:off x="3420765" y="1450560"/>
            <a:ext cx="7649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2nd</a:t>
            </a:r>
            <a:endParaRPr lang="zh-CN" altLang="en-US" sz="280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2F8DC25D-DBB5-E9DC-91CE-BDD8D6F4AD03}"/>
              </a:ext>
            </a:extLst>
          </p:cNvPr>
          <p:cNvSpPr txBox="1"/>
          <p:nvPr/>
        </p:nvSpPr>
        <p:spPr>
          <a:xfrm>
            <a:off x="5019642" y="1450560"/>
            <a:ext cx="7232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3rd</a:t>
            </a:r>
            <a:endParaRPr lang="zh-CN" altLang="en-US" sz="2800" dirty="0"/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DD53C0FD-672B-BF0A-6B1D-2FA6C1B019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92840">
            <a:off x="7238627" y="1895488"/>
            <a:ext cx="4597636" cy="3581584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A489B9EF-C5D8-9CD2-2BCE-E4709B0A4BD5}"/>
              </a:ext>
            </a:extLst>
          </p:cNvPr>
          <p:cNvSpPr txBox="1"/>
          <p:nvPr/>
        </p:nvSpPr>
        <p:spPr>
          <a:xfrm>
            <a:off x="7604773" y="1444786"/>
            <a:ext cx="6238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1st</a:t>
            </a:r>
            <a:endParaRPr lang="zh-CN" altLang="en-US" sz="28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6AA6CA3-A36E-C977-E4D7-517BD0074C81}"/>
              </a:ext>
            </a:extLst>
          </p:cNvPr>
          <p:cNvSpPr txBox="1"/>
          <p:nvPr/>
        </p:nvSpPr>
        <p:spPr>
          <a:xfrm>
            <a:off x="9017998" y="1444786"/>
            <a:ext cx="7649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2nd</a:t>
            </a:r>
            <a:endParaRPr lang="zh-CN" altLang="en-US" sz="28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7B72F10A-3C21-CE75-E9FD-6CD92E4FFFA4}"/>
              </a:ext>
            </a:extLst>
          </p:cNvPr>
          <p:cNvSpPr txBox="1"/>
          <p:nvPr/>
        </p:nvSpPr>
        <p:spPr>
          <a:xfrm>
            <a:off x="10713858" y="1444786"/>
            <a:ext cx="7232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3rd</a:t>
            </a:r>
            <a:endParaRPr lang="zh-CN" altLang="en-US" sz="28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B0227B4-390C-3F80-D5B7-3F1D462F62F1}"/>
              </a:ext>
            </a:extLst>
          </p:cNvPr>
          <p:cNvSpPr txBox="1"/>
          <p:nvPr/>
        </p:nvSpPr>
        <p:spPr>
          <a:xfrm>
            <a:off x="6103133" y="3995571"/>
            <a:ext cx="1520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D4F04CC-4743-30E3-89E8-A72F35F747AE}"/>
              </a:ext>
            </a:extLst>
          </p:cNvPr>
          <p:cNvSpPr txBox="1"/>
          <p:nvPr/>
        </p:nvSpPr>
        <p:spPr>
          <a:xfrm rot="16200000">
            <a:off x="2007024" y="5802873"/>
            <a:ext cx="1048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310E1A4-5B46-83D3-DCBD-E0C6E0E91487}"/>
              </a:ext>
            </a:extLst>
          </p:cNvPr>
          <p:cNvSpPr txBox="1"/>
          <p:nvPr/>
        </p:nvSpPr>
        <p:spPr>
          <a:xfrm rot="16200000">
            <a:off x="1640739" y="5802873"/>
            <a:ext cx="1048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E44F29B-572C-5A38-A565-FBC4A92FBEF4}"/>
              </a:ext>
            </a:extLst>
          </p:cNvPr>
          <p:cNvSpPr txBox="1"/>
          <p:nvPr/>
        </p:nvSpPr>
        <p:spPr>
          <a:xfrm rot="16200000">
            <a:off x="3572588" y="5802874"/>
            <a:ext cx="1048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9252A674-2467-B8C9-109A-1BE2EE8D7037}"/>
              </a:ext>
            </a:extLst>
          </p:cNvPr>
          <p:cNvSpPr txBox="1"/>
          <p:nvPr/>
        </p:nvSpPr>
        <p:spPr>
          <a:xfrm rot="16200000">
            <a:off x="3206303" y="5802874"/>
            <a:ext cx="1048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54E6E9BA-CA61-3F04-1259-34ABFB8250EF}"/>
              </a:ext>
            </a:extLst>
          </p:cNvPr>
          <p:cNvSpPr txBox="1"/>
          <p:nvPr/>
        </p:nvSpPr>
        <p:spPr>
          <a:xfrm rot="16200000">
            <a:off x="5118186" y="5802874"/>
            <a:ext cx="1048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769203C-36B0-FDA8-0B81-7055D06FDB43}"/>
              </a:ext>
            </a:extLst>
          </p:cNvPr>
          <p:cNvSpPr txBox="1"/>
          <p:nvPr/>
        </p:nvSpPr>
        <p:spPr>
          <a:xfrm rot="16200000">
            <a:off x="4751901" y="5802874"/>
            <a:ext cx="1048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90BE225E-8AEF-EC08-E3E8-76F319926B61}"/>
              </a:ext>
            </a:extLst>
          </p:cNvPr>
          <p:cNvSpPr txBox="1"/>
          <p:nvPr/>
        </p:nvSpPr>
        <p:spPr>
          <a:xfrm rot="16200000">
            <a:off x="7519899" y="5802874"/>
            <a:ext cx="1048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D952340-53AA-289E-4FC7-BBA1CFE0DC31}"/>
              </a:ext>
            </a:extLst>
          </p:cNvPr>
          <p:cNvSpPr txBox="1"/>
          <p:nvPr/>
        </p:nvSpPr>
        <p:spPr>
          <a:xfrm rot="16200000">
            <a:off x="7153614" y="5802874"/>
            <a:ext cx="1048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D52F6EB-2717-53D3-77E4-DBF4CC688983}"/>
              </a:ext>
            </a:extLst>
          </p:cNvPr>
          <p:cNvSpPr txBox="1"/>
          <p:nvPr/>
        </p:nvSpPr>
        <p:spPr>
          <a:xfrm rot="16200000">
            <a:off x="8962005" y="5802873"/>
            <a:ext cx="1048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43C24A30-F10C-57A1-2000-CE21F7BBB1A9}"/>
              </a:ext>
            </a:extLst>
          </p:cNvPr>
          <p:cNvSpPr txBox="1"/>
          <p:nvPr/>
        </p:nvSpPr>
        <p:spPr>
          <a:xfrm rot="16200000">
            <a:off x="8595720" y="5802873"/>
            <a:ext cx="1048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41C35B1-B840-78E0-5EE7-50447FFC4F22}"/>
              </a:ext>
            </a:extLst>
          </p:cNvPr>
          <p:cNvSpPr txBox="1"/>
          <p:nvPr/>
        </p:nvSpPr>
        <p:spPr>
          <a:xfrm rot="16200000">
            <a:off x="10738481" y="5802874"/>
            <a:ext cx="1048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AE2922F-DEE4-F124-DE6C-64441D3025FE}"/>
              </a:ext>
            </a:extLst>
          </p:cNvPr>
          <p:cNvSpPr txBox="1"/>
          <p:nvPr/>
        </p:nvSpPr>
        <p:spPr>
          <a:xfrm rot="16200000">
            <a:off x="10372196" y="5802874"/>
            <a:ext cx="1048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478844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>
            <a:extLst>
              <a:ext uri="{FF2B5EF4-FFF2-40B4-BE49-F238E27FC236}">
                <a16:creationId xmlns:a16="http://schemas.microsoft.com/office/drawing/2014/main" id="{BFA32EC2-C4A6-C3AC-B3EE-D2BAF3FAB2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47376" y="1573630"/>
            <a:ext cx="3547103" cy="1322545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A1075AB8-678F-A72A-2D51-6EE8F5C39F9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50171" y="1713219"/>
            <a:ext cx="3007055" cy="133456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FC04F9B9-8B4B-4946-21B7-77838CCC83A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9517" y="2910952"/>
            <a:ext cx="3156213" cy="117815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14489412-477F-5524-C773-1AD95153630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0938" y="1598103"/>
            <a:ext cx="3813372" cy="1503349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D18E89CD-3AEA-DD33-6238-B9C90FC5120E}"/>
              </a:ext>
            </a:extLst>
          </p:cNvPr>
          <p:cNvSpPr txBox="1"/>
          <p:nvPr/>
        </p:nvSpPr>
        <p:spPr>
          <a:xfrm>
            <a:off x="625764" y="447964"/>
            <a:ext cx="3281604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FIG.6B</a:t>
            </a:r>
          </a:p>
          <a:p>
            <a:r>
              <a:rPr lang="en-US" altLang="zh-CN" dirty="0"/>
              <a:t>Cropped membrane</a:t>
            </a:r>
            <a:endParaRPr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FAB1EA63-12E9-9CCE-0D7C-4DA61A135B51}"/>
              </a:ext>
            </a:extLst>
          </p:cNvPr>
          <p:cNvSpPr txBox="1"/>
          <p:nvPr/>
        </p:nvSpPr>
        <p:spPr>
          <a:xfrm>
            <a:off x="2289108" y="1458716"/>
            <a:ext cx="6238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1st</a:t>
            </a:r>
            <a:endParaRPr lang="zh-CN" altLang="en-US" sz="2800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35DE3337-BDC8-D4BA-5EDB-1B40A0387D84}"/>
              </a:ext>
            </a:extLst>
          </p:cNvPr>
          <p:cNvSpPr txBox="1"/>
          <p:nvPr/>
        </p:nvSpPr>
        <p:spPr>
          <a:xfrm>
            <a:off x="5722340" y="1458716"/>
            <a:ext cx="7649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2nd</a:t>
            </a:r>
            <a:endParaRPr lang="zh-CN" altLang="en-US" sz="2800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88F245EF-C1E1-A848-091B-0A0EEE4E547A}"/>
              </a:ext>
            </a:extLst>
          </p:cNvPr>
          <p:cNvSpPr txBox="1"/>
          <p:nvPr/>
        </p:nvSpPr>
        <p:spPr>
          <a:xfrm>
            <a:off x="9369970" y="1458716"/>
            <a:ext cx="7232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3rd</a:t>
            </a:r>
            <a:endParaRPr lang="zh-CN" altLang="en-US" sz="2800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C5FC1FC-7C4C-1282-4E49-C06C4F15447D}"/>
              </a:ext>
            </a:extLst>
          </p:cNvPr>
          <p:cNvSpPr txBox="1"/>
          <p:nvPr/>
        </p:nvSpPr>
        <p:spPr>
          <a:xfrm>
            <a:off x="0" y="2284353"/>
            <a:ext cx="1755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014EA10-2EC6-3DFC-E4E4-7C5AF713E9E6}"/>
              </a:ext>
            </a:extLst>
          </p:cNvPr>
          <p:cNvSpPr txBox="1"/>
          <p:nvPr/>
        </p:nvSpPr>
        <p:spPr>
          <a:xfrm>
            <a:off x="28826" y="3453676"/>
            <a:ext cx="1755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3B53592-4D67-2555-1365-E99455C2F359}"/>
              </a:ext>
            </a:extLst>
          </p:cNvPr>
          <p:cNvSpPr txBox="1"/>
          <p:nvPr/>
        </p:nvSpPr>
        <p:spPr>
          <a:xfrm rot="16200000">
            <a:off x="965013" y="4572629"/>
            <a:ext cx="1832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986CF52-F2F0-F083-A5E4-FA70130134AC}"/>
              </a:ext>
            </a:extLst>
          </p:cNvPr>
          <p:cNvSpPr txBox="1"/>
          <p:nvPr/>
        </p:nvSpPr>
        <p:spPr>
          <a:xfrm rot="16200000">
            <a:off x="1525155" y="4567757"/>
            <a:ext cx="1832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+TGF-β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039F66E-CE3E-BD5D-17B3-8C8A77A8B646}"/>
              </a:ext>
            </a:extLst>
          </p:cNvPr>
          <p:cNvSpPr txBox="1"/>
          <p:nvPr/>
        </p:nvSpPr>
        <p:spPr>
          <a:xfrm rot="16200000">
            <a:off x="1761508" y="4870341"/>
            <a:ext cx="2437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+TGF-β1+AHW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05A7F7C5-612D-3B5A-159C-A4643AC5B63B}"/>
              </a:ext>
            </a:extLst>
          </p:cNvPr>
          <p:cNvSpPr txBox="1"/>
          <p:nvPr/>
        </p:nvSpPr>
        <p:spPr>
          <a:xfrm rot="16200000">
            <a:off x="2022711" y="5169279"/>
            <a:ext cx="30355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GF-β1+AHWE+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DFE601E2-D138-29D4-1021-AF5E4572EAC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01012" y="2797418"/>
            <a:ext cx="3156214" cy="1165006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C353A41E-6991-FF83-E315-FD3D4AAF86D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24391" y="2669652"/>
            <a:ext cx="2958409" cy="1165006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CA81B7EA-D695-D3C6-F61A-7F193FDBE914}"/>
              </a:ext>
            </a:extLst>
          </p:cNvPr>
          <p:cNvSpPr txBox="1"/>
          <p:nvPr/>
        </p:nvSpPr>
        <p:spPr>
          <a:xfrm rot="16200000">
            <a:off x="4231104" y="4617967"/>
            <a:ext cx="1832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3CF42DA-4A3C-9F86-024D-9D057B6EA98A}"/>
              </a:ext>
            </a:extLst>
          </p:cNvPr>
          <p:cNvSpPr txBox="1"/>
          <p:nvPr/>
        </p:nvSpPr>
        <p:spPr>
          <a:xfrm rot="16200000">
            <a:off x="4791246" y="4613095"/>
            <a:ext cx="1832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+TGF-β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870ACE07-C6D0-9DF4-8ED0-7F5BADBAE15B}"/>
              </a:ext>
            </a:extLst>
          </p:cNvPr>
          <p:cNvSpPr txBox="1"/>
          <p:nvPr/>
        </p:nvSpPr>
        <p:spPr>
          <a:xfrm rot="16200000">
            <a:off x="5027599" y="4915679"/>
            <a:ext cx="2437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+TGF-β1+AHW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3F3B367-3E42-BD57-F2FA-2FC8D91380E9}"/>
              </a:ext>
            </a:extLst>
          </p:cNvPr>
          <p:cNvSpPr txBox="1"/>
          <p:nvPr/>
        </p:nvSpPr>
        <p:spPr>
          <a:xfrm rot="16200000">
            <a:off x="5288802" y="5214617"/>
            <a:ext cx="30355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GF-β1+AHWE+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EB3EAB91-8B14-DADA-5772-1D5F88D2E4FB}"/>
              </a:ext>
            </a:extLst>
          </p:cNvPr>
          <p:cNvSpPr txBox="1"/>
          <p:nvPr/>
        </p:nvSpPr>
        <p:spPr>
          <a:xfrm rot="16200000">
            <a:off x="7953897" y="4559448"/>
            <a:ext cx="1832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F247292-7FE2-F2E8-42F7-30D3BF365851}"/>
              </a:ext>
            </a:extLst>
          </p:cNvPr>
          <p:cNvSpPr txBox="1"/>
          <p:nvPr/>
        </p:nvSpPr>
        <p:spPr>
          <a:xfrm rot="16200000">
            <a:off x="8514039" y="4554576"/>
            <a:ext cx="1832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+TGF-β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8D9F9014-3354-23DC-5FAE-E9341D807D3C}"/>
              </a:ext>
            </a:extLst>
          </p:cNvPr>
          <p:cNvSpPr txBox="1"/>
          <p:nvPr/>
        </p:nvSpPr>
        <p:spPr>
          <a:xfrm rot="16200000">
            <a:off x="8750392" y="4857160"/>
            <a:ext cx="2437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3+TGF-β1+AHW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6EF5BD99-D056-7CBA-F2EF-C48BDDD418C0}"/>
              </a:ext>
            </a:extLst>
          </p:cNvPr>
          <p:cNvSpPr txBox="1"/>
          <p:nvPr/>
        </p:nvSpPr>
        <p:spPr>
          <a:xfrm rot="16200000">
            <a:off x="9011595" y="5156098"/>
            <a:ext cx="30355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GF-β1+AHWE+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570124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6BC0816-5D0C-44A9-9FC9-02EB4EE062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74860" y="870987"/>
            <a:ext cx="2549097" cy="3312092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0F8A123A-14BB-EC12-6EC7-6BD4F0E4E785}"/>
              </a:ext>
            </a:extLst>
          </p:cNvPr>
          <p:cNvSpPr txBox="1"/>
          <p:nvPr/>
        </p:nvSpPr>
        <p:spPr>
          <a:xfrm>
            <a:off x="625764" y="447964"/>
            <a:ext cx="254909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FIG.6B</a:t>
            </a:r>
          </a:p>
          <a:p>
            <a:r>
              <a:rPr lang="en-US" altLang="zh-CN" dirty="0"/>
              <a:t>Full membrane</a:t>
            </a:r>
          </a:p>
          <a:p>
            <a:r>
              <a:rPr lang="en-US" altLang="zh-CN" dirty="0"/>
              <a:t>1st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D7AB3BB-D7BD-F478-4E2D-FA9BB8BF92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12154" y="434637"/>
            <a:ext cx="2555178" cy="3916347"/>
          </a:xfrm>
          <a:prstGeom prst="rect">
            <a:avLst/>
          </a:prstGeom>
        </p:spPr>
      </p:pic>
      <p:grpSp>
        <p:nvGrpSpPr>
          <p:cNvPr id="10" name="组合 9">
            <a:extLst>
              <a:ext uri="{FF2B5EF4-FFF2-40B4-BE49-F238E27FC236}">
                <a16:creationId xmlns:a16="http://schemas.microsoft.com/office/drawing/2014/main" id="{AEA25506-5C75-41E1-EB80-AB413BA437B3}"/>
              </a:ext>
            </a:extLst>
          </p:cNvPr>
          <p:cNvGrpSpPr/>
          <p:nvPr/>
        </p:nvGrpSpPr>
        <p:grpSpPr>
          <a:xfrm>
            <a:off x="8006591" y="4252500"/>
            <a:ext cx="1910791" cy="3035511"/>
            <a:chOff x="7611736" y="4342554"/>
            <a:chExt cx="1910791" cy="3035511"/>
          </a:xfrm>
        </p:grpSpPr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0C8F04A7-3DEE-DAB0-9311-D3ECBE553F57}"/>
                </a:ext>
              </a:extLst>
            </p:cNvPr>
            <p:cNvSpPr txBox="1"/>
            <p:nvPr/>
          </p:nvSpPr>
          <p:spPr>
            <a:xfrm rot="16200000">
              <a:off x="6880170" y="5078994"/>
              <a:ext cx="18324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A19F5A5F-898D-1305-6000-2DC09302B1DB}"/>
                </a:ext>
              </a:extLst>
            </p:cNvPr>
            <p:cNvSpPr txBox="1"/>
            <p:nvPr/>
          </p:nvSpPr>
          <p:spPr>
            <a:xfrm rot="16200000">
              <a:off x="7393990" y="5074122"/>
              <a:ext cx="18324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+TGF-β1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D6A73AA5-C679-2ED5-1B69-35692A676682}"/>
                </a:ext>
              </a:extLst>
            </p:cNvPr>
            <p:cNvSpPr txBox="1"/>
            <p:nvPr/>
          </p:nvSpPr>
          <p:spPr>
            <a:xfrm rot="16200000">
              <a:off x="7605225" y="5376706"/>
              <a:ext cx="24376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+TGF-β1+AHWE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95B51DA9-BF5F-EAB9-B946-1F14178E371C}"/>
                </a:ext>
              </a:extLst>
            </p:cNvPr>
            <p:cNvSpPr txBox="1"/>
            <p:nvPr/>
          </p:nvSpPr>
          <p:spPr>
            <a:xfrm rot="16200000">
              <a:off x="7820105" y="5675644"/>
              <a:ext cx="30355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GF-β1+AHWE+STAT3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E1BE7210-174B-4C67-86FB-25C5A9545AC5}"/>
              </a:ext>
            </a:extLst>
          </p:cNvPr>
          <p:cNvGrpSpPr/>
          <p:nvPr/>
        </p:nvGrpSpPr>
        <p:grpSpPr>
          <a:xfrm>
            <a:off x="3482716" y="4252501"/>
            <a:ext cx="1910791" cy="3035511"/>
            <a:chOff x="7611736" y="4342554"/>
            <a:chExt cx="1910791" cy="3035511"/>
          </a:xfrm>
        </p:grpSpPr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26BDE8B6-BE4B-4522-9EE5-D302DC31C647}"/>
                </a:ext>
              </a:extLst>
            </p:cNvPr>
            <p:cNvSpPr txBox="1"/>
            <p:nvPr/>
          </p:nvSpPr>
          <p:spPr>
            <a:xfrm rot="16200000">
              <a:off x="6880170" y="5078994"/>
              <a:ext cx="18324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6F209F21-23CA-4E0C-9E0E-C60C2A0D4BBA}"/>
                </a:ext>
              </a:extLst>
            </p:cNvPr>
            <p:cNvSpPr txBox="1"/>
            <p:nvPr/>
          </p:nvSpPr>
          <p:spPr>
            <a:xfrm rot="16200000">
              <a:off x="7393990" y="5074122"/>
              <a:ext cx="18324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+TGF-β1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C84B8BC7-4A77-4B35-9C82-BAC60BEE6BE1}"/>
                </a:ext>
              </a:extLst>
            </p:cNvPr>
            <p:cNvSpPr txBox="1"/>
            <p:nvPr/>
          </p:nvSpPr>
          <p:spPr>
            <a:xfrm rot="16200000">
              <a:off x="7605225" y="5376706"/>
              <a:ext cx="24376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+TGF-β1+AHWE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A58E2CFF-A9DE-4B08-99F8-E96C2448B1DA}"/>
                </a:ext>
              </a:extLst>
            </p:cNvPr>
            <p:cNvSpPr txBox="1"/>
            <p:nvPr/>
          </p:nvSpPr>
          <p:spPr>
            <a:xfrm rot="16200000">
              <a:off x="7820105" y="5675644"/>
              <a:ext cx="30355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GF-β1+AHWE+STAT3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文本框 19">
            <a:extLst>
              <a:ext uri="{FF2B5EF4-FFF2-40B4-BE49-F238E27FC236}">
                <a16:creationId xmlns:a16="http://schemas.microsoft.com/office/drawing/2014/main" id="{55F5D0B3-1980-4827-8423-A63D09CD3606}"/>
              </a:ext>
            </a:extLst>
          </p:cNvPr>
          <p:cNvSpPr txBox="1"/>
          <p:nvPr/>
        </p:nvSpPr>
        <p:spPr>
          <a:xfrm>
            <a:off x="1707353" y="2269809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FFFB8115-B9CE-4A26-81D0-C5EDA415BACE}"/>
              </a:ext>
            </a:extLst>
          </p:cNvPr>
          <p:cNvSpPr txBox="1"/>
          <p:nvPr/>
        </p:nvSpPr>
        <p:spPr>
          <a:xfrm>
            <a:off x="6205057" y="2756565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414697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F8A123A-14BB-EC12-6EC7-6BD4F0E4E785}"/>
              </a:ext>
            </a:extLst>
          </p:cNvPr>
          <p:cNvSpPr txBox="1"/>
          <p:nvPr/>
        </p:nvSpPr>
        <p:spPr>
          <a:xfrm>
            <a:off x="625764" y="447964"/>
            <a:ext cx="254909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FIG.6B</a:t>
            </a:r>
          </a:p>
          <a:p>
            <a:r>
              <a:rPr lang="en-US" altLang="zh-CN" dirty="0"/>
              <a:t>Full membrane</a:t>
            </a:r>
          </a:p>
          <a:p>
            <a:r>
              <a:rPr lang="en-US" altLang="zh-CN" dirty="0"/>
              <a:t>2nd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09AA27F-51AD-021A-DF25-9740346020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78341">
            <a:off x="7404803" y="185565"/>
            <a:ext cx="2838477" cy="4292710"/>
          </a:xfrm>
          <a:prstGeom prst="rect">
            <a:avLst/>
          </a:prstGeom>
        </p:spPr>
      </p:pic>
      <p:grpSp>
        <p:nvGrpSpPr>
          <p:cNvPr id="5" name="组合 4">
            <a:extLst>
              <a:ext uri="{FF2B5EF4-FFF2-40B4-BE49-F238E27FC236}">
                <a16:creationId xmlns:a16="http://schemas.microsoft.com/office/drawing/2014/main" id="{8990155B-6297-8C67-DCBE-B52099053DE2}"/>
              </a:ext>
            </a:extLst>
          </p:cNvPr>
          <p:cNvGrpSpPr/>
          <p:nvPr/>
        </p:nvGrpSpPr>
        <p:grpSpPr>
          <a:xfrm>
            <a:off x="8006591" y="4252500"/>
            <a:ext cx="1910791" cy="3035511"/>
            <a:chOff x="7611736" y="4342554"/>
            <a:chExt cx="1910791" cy="3035511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2062E0F9-DBC1-EC1B-6372-7CFE13C455D4}"/>
                </a:ext>
              </a:extLst>
            </p:cNvPr>
            <p:cNvSpPr txBox="1"/>
            <p:nvPr/>
          </p:nvSpPr>
          <p:spPr>
            <a:xfrm rot="16200000">
              <a:off x="6880170" y="5078994"/>
              <a:ext cx="18324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25F8C3B3-615C-824B-A285-75EC4452A832}"/>
                </a:ext>
              </a:extLst>
            </p:cNvPr>
            <p:cNvSpPr txBox="1"/>
            <p:nvPr/>
          </p:nvSpPr>
          <p:spPr>
            <a:xfrm rot="16200000">
              <a:off x="7393990" y="5074122"/>
              <a:ext cx="18324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+TGF-β1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264EB242-5F5D-2E9B-4A6E-886F8970CEDD}"/>
                </a:ext>
              </a:extLst>
            </p:cNvPr>
            <p:cNvSpPr txBox="1"/>
            <p:nvPr/>
          </p:nvSpPr>
          <p:spPr>
            <a:xfrm rot="16200000">
              <a:off x="7605225" y="5376706"/>
              <a:ext cx="24376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+TGF-β1+AHWE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F27D6A1F-5485-B32C-E922-A2705BF1CBD2}"/>
                </a:ext>
              </a:extLst>
            </p:cNvPr>
            <p:cNvSpPr txBox="1"/>
            <p:nvPr/>
          </p:nvSpPr>
          <p:spPr>
            <a:xfrm rot="16200000">
              <a:off x="7820105" y="5675644"/>
              <a:ext cx="30355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GF-β1+AHWE+STAT3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0" name="图片 9">
            <a:extLst>
              <a:ext uri="{FF2B5EF4-FFF2-40B4-BE49-F238E27FC236}">
                <a16:creationId xmlns:a16="http://schemas.microsoft.com/office/drawing/2014/main" id="{479BF5DD-611D-4A8C-A08B-E176211229B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263" t="6104" r="50969" b="13018"/>
          <a:stretch/>
        </p:blipFill>
        <p:spPr>
          <a:xfrm>
            <a:off x="3205912" y="447964"/>
            <a:ext cx="2506998" cy="3883133"/>
          </a:xfrm>
          <a:prstGeom prst="rect">
            <a:avLst/>
          </a:prstGeom>
        </p:spPr>
      </p:pic>
      <p:grpSp>
        <p:nvGrpSpPr>
          <p:cNvPr id="12" name="组合 11">
            <a:extLst>
              <a:ext uri="{FF2B5EF4-FFF2-40B4-BE49-F238E27FC236}">
                <a16:creationId xmlns:a16="http://schemas.microsoft.com/office/drawing/2014/main" id="{0FAFAE59-89F8-470C-82E4-C45A01B1BA58}"/>
              </a:ext>
            </a:extLst>
          </p:cNvPr>
          <p:cNvGrpSpPr/>
          <p:nvPr/>
        </p:nvGrpSpPr>
        <p:grpSpPr>
          <a:xfrm>
            <a:off x="3578348" y="4252501"/>
            <a:ext cx="1910791" cy="3035511"/>
            <a:chOff x="7611736" y="4342554"/>
            <a:chExt cx="1910791" cy="3035511"/>
          </a:xfrm>
        </p:grpSpPr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D50D59DF-E22C-490C-AABB-619C76B1BC6C}"/>
                </a:ext>
              </a:extLst>
            </p:cNvPr>
            <p:cNvSpPr txBox="1"/>
            <p:nvPr/>
          </p:nvSpPr>
          <p:spPr>
            <a:xfrm rot="16200000">
              <a:off x="6880170" y="5078994"/>
              <a:ext cx="18324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5B3E30B1-7667-415D-AD47-A3D91EAB5DF6}"/>
                </a:ext>
              </a:extLst>
            </p:cNvPr>
            <p:cNvSpPr txBox="1"/>
            <p:nvPr/>
          </p:nvSpPr>
          <p:spPr>
            <a:xfrm rot="16200000">
              <a:off x="7393990" y="5074122"/>
              <a:ext cx="18324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+TGF-β1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C5C8C8F5-213D-438E-B9A9-FBC65C0A109F}"/>
                </a:ext>
              </a:extLst>
            </p:cNvPr>
            <p:cNvSpPr txBox="1"/>
            <p:nvPr/>
          </p:nvSpPr>
          <p:spPr>
            <a:xfrm rot="16200000">
              <a:off x="7605225" y="5376706"/>
              <a:ext cx="24376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+TGF-β1+AHWE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E17B5F0A-11D3-45CE-962D-FD3A8C52EBD7}"/>
                </a:ext>
              </a:extLst>
            </p:cNvPr>
            <p:cNvSpPr txBox="1"/>
            <p:nvPr/>
          </p:nvSpPr>
          <p:spPr>
            <a:xfrm rot="16200000">
              <a:off x="7820105" y="5675644"/>
              <a:ext cx="30355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GF-β1+AHWE+STAT3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文本框 16">
            <a:extLst>
              <a:ext uri="{FF2B5EF4-FFF2-40B4-BE49-F238E27FC236}">
                <a16:creationId xmlns:a16="http://schemas.microsoft.com/office/drawing/2014/main" id="{AD28A1E5-64AE-46B8-B2F1-7154DCB48F04}"/>
              </a:ext>
            </a:extLst>
          </p:cNvPr>
          <p:cNvSpPr txBox="1"/>
          <p:nvPr/>
        </p:nvSpPr>
        <p:spPr>
          <a:xfrm>
            <a:off x="1841577" y="2129555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6436C44-2AE0-41D4-8E74-7B63B29991A9}"/>
              </a:ext>
            </a:extLst>
          </p:cNvPr>
          <p:cNvSpPr txBox="1"/>
          <p:nvPr/>
        </p:nvSpPr>
        <p:spPr>
          <a:xfrm>
            <a:off x="6339281" y="2616311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124866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F8A123A-14BB-EC12-6EC7-6BD4F0E4E785}"/>
              </a:ext>
            </a:extLst>
          </p:cNvPr>
          <p:cNvSpPr txBox="1"/>
          <p:nvPr/>
        </p:nvSpPr>
        <p:spPr>
          <a:xfrm>
            <a:off x="625764" y="447964"/>
            <a:ext cx="254909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FIG.6B</a:t>
            </a:r>
          </a:p>
          <a:p>
            <a:r>
              <a:rPr lang="en-US" altLang="zh-CN" dirty="0"/>
              <a:t>Full membrane</a:t>
            </a:r>
          </a:p>
          <a:p>
            <a:r>
              <a:rPr lang="en-US" altLang="zh-CN" dirty="0"/>
              <a:t>3rd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A155D7A-4312-EA14-66C4-428186B0DB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15150" y="0"/>
            <a:ext cx="2618456" cy="4727548"/>
          </a:xfrm>
          <a:prstGeom prst="rect">
            <a:avLst/>
          </a:prstGeom>
        </p:spPr>
      </p:pic>
      <p:grpSp>
        <p:nvGrpSpPr>
          <p:cNvPr id="5" name="组合 4">
            <a:extLst>
              <a:ext uri="{FF2B5EF4-FFF2-40B4-BE49-F238E27FC236}">
                <a16:creationId xmlns:a16="http://schemas.microsoft.com/office/drawing/2014/main" id="{C645EC36-1449-473E-58F1-3411A105EF59}"/>
              </a:ext>
            </a:extLst>
          </p:cNvPr>
          <p:cNvGrpSpPr/>
          <p:nvPr/>
        </p:nvGrpSpPr>
        <p:grpSpPr>
          <a:xfrm>
            <a:off x="8006591" y="4252500"/>
            <a:ext cx="1910791" cy="3035511"/>
            <a:chOff x="7611736" y="4342554"/>
            <a:chExt cx="1910791" cy="3035511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21D49892-832C-1C1C-FD36-E034683A77DF}"/>
                </a:ext>
              </a:extLst>
            </p:cNvPr>
            <p:cNvSpPr txBox="1"/>
            <p:nvPr/>
          </p:nvSpPr>
          <p:spPr>
            <a:xfrm rot="16200000">
              <a:off x="6880170" y="5078994"/>
              <a:ext cx="18324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17B8E3AD-80DB-C4DB-768D-8900F234FBF2}"/>
                </a:ext>
              </a:extLst>
            </p:cNvPr>
            <p:cNvSpPr txBox="1"/>
            <p:nvPr/>
          </p:nvSpPr>
          <p:spPr>
            <a:xfrm rot="16200000">
              <a:off x="7393990" y="5074122"/>
              <a:ext cx="18324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+TGF-β1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2504DB92-81EE-4B49-192A-2A629568186A}"/>
                </a:ext>
              </a:extLst>
            </p:cNvPr>
            <p:cNvSpPr txBox="1"/>
            <p:nvPr/>
          </p:nvSpPr>
          <p:spPr>
            <a:xfrm rot="16200000">
              <a:off x="7605225" y="5376706"/>
              <a:ext cx="24376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+TGF-β1+AHWE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987F9160-189A-B995-7AC1-36C7C0F6156F}"/>
                </a:ext>
              </a:extLst>
            </p:cNvPr>
            <p:cNvSpPr txBox="1"/>
            <p:nvPr/>
          </p:nvSpPr>
          <p:spPr>
            <a:xfrm rot="16200000">
              <a:off x="7820105" y="5675644"/>
              <a:ext cx="30355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GF-β1+AHWE+STAT3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0" name="图片 9">
            <a:extLst>
              <a:ext uri="{FF2B5EF4-FFF2-40B4-BE49-F238E27FC236}">
                <a16:creationId xmlns:a16="http://schemas.microsoft.com/office/drawing/2014/main" id="{D0674CB4-199A-41AC-A1D3-8248A40A783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6504" t="5695" r="4892" b="5711"/>
          <a:stretch/>
        </p:blipFill>
        <p:spPr>
          <a:xfrm rot="239130">
            <a:off x="3268074" y="744648"/>
            <a:ext cx="2509397" cy="4009254"/>
          </a:xfrm>
          <a:prstGeom prst="rect">
            <a:avLst/>
          </a:prstGeom>
        </p:spPr>
      </p:pic>
      <p:grpSp>
        <p:nvGrpSpPr>
          <p:cNvPr id="11" name="组合 10">
            <a:extLst>
              <a:ext uri="{FF2B5EF4-FFF2-40B4-BE49-F238E27FC236}">
                <a16:creationId xmlns:a16="http://schemas.microsoft.com/office/drawing/2014/main" id="{2E780824-923F-4B06-BEC8-8342F39CC5BC}"/>
              </a:ext>
            </a:extLst>
          </p:cNvPr>
          <p:cNvGrpSpPr/>
          <p:nvPr/>
        </p:nvGrpSpPr>
        <p:grpSpPr>
          <a:xfrm>
            <a:off x="3484214" y="4252501"/>
            <a:ext cx="1910791" cy="3035511"/>
            <a:chOff x="7611736" y="4342554"/>
            <a:chExt cx="1910791" cy="3035511"/>
          </a:xfrm>
        </p:grpSpPr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D8E1B291-2406-40A0-BB24-212A5CBF607D}"/>
                </a:ext>
              </a:extLst>
            </p:cNvPr>
            <p:cNvSpPr txBox="1"/>
            <p:nvPr/>
          </p:nvSpPr>
          <p:spPr>
            <a:xfrm rot="16200000">
              <a:off x="6880170" y="5078994"/>
              <a:ext cx="18324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A2F3F63E-BFB1-406F-A551-447F119079FD}"/>
                </a:ext>
              </a:extLst>
            </p:cNvPr>
            <p:cNvSpPr txBox="1"/>
            <p:nvPr/>
          </p:nvSpPr>
          <p:spPr>
            <a:xfrm rot="16200000">
              <a:off x="7393990" y="5074122"/>
              <a:ext cx="18324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+TGF-β1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6BDA334C-F4D3-490F-9094-2483256BC78A}"/>
                </a:ext>
              </a:extLst>
            </p:cNvPr>
            <p:cNvSpPr txBox="1"/>
            <p:nvPr/>
          </p:nvSpPr>
          <p:spPr>
            <a:xfrm rot="16200000">
              <a:off x="7605225" y="5376706"/>
              <a:ext cx="24376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N3+TGF-β1+AHWE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45ABFA59-FFC6-4205-B085-625A5D6565E7}"/>
                </a:ext>
              </a:extLst>
            </p:cNvPr>
            <p:cNvSpPr txBox="1"/>
            <p:nvPr/>
          </p:nvSpPr>
          <p:spPr>
            <a:xfrm rot="16200000">
              <a:off x="7820105" y="5675644"/>
              <a:ext cx="30355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GF-β1+AHWE+STAT3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文本框 15">
            <a:extLst>
              <a:ext uri="{FF2B5EF4-FFF2-40B4-BE49-F238E27FC236}">
                <a16:creationId xmlns:a16="http://schemas.microsoft.com/office/drawing/2014/main" id="{C197A197-91FB-47D9-9B91-3B5DC4E2CD70}"/>
              </a:ext>
            </a:extLst>
          </p:cNvPr>
          <p:cNvSpPr txBox="1"/>
          <p:nvPr/>
        </p:nvSpPr>
        <p:spPr>
          <a:xfrm>
            <a:off x="1780531" y="2279428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0841C64-2F4E-453C-9452-FE792DF1D993}"/>
              </a:ext>
            </a:extLst>
          </p:cNvPr>
          <p:cNvSpPr txBox="1"/>
          <p:nvPr/>
        </p:nvSpPr>
        <p:spPr>
          <a:xfrm>
            <a:off x="6278235" y="2766184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622907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D34CB939-D7EB-1562-9E4F-996CFB5C2636}"/>
              </a:ext>
            </a:extLst>
          </p:cNvPr>
          <p:cNvSpPr txBox="1"/>
          <p:nvPr/>
        </p:nvSpPr>
        <p:spPr>
          <a:xfrm>
            <a:off x="625764" y="447964"/>
            <a:ext cx="3281604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FIG.7B</a:t>
            </a:r>
          </a:p>
          <a:p>
            <a:r>
              <a:rPr lang="en-US" altLang="zh-CN" dirty="0"/>
              <a:t>Cropped membrane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93CE08A-88DC-524A-DC45-E01CCA434EE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675" t="22951" r="9409" b="12867"/>
          <a:stretch/>
        </p:blipFill>
        <p:spPr>
          <a:xfrm>
            <a:off x="1483475" y="3849806"/>
            <a:ext cx="2644022" cy="357213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7DD01E28-B2A0-F4BD-321B-269DD4BD150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094" t="20933" r="11763" b="22582"/>
          <a:stretch/>
        </p:blipFill>
        <p:spPr>
          <a:xfrm>
            <a:off x="1483475" y="2910546"/>
            <a:ext cx="2644022" cy="480223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EBFB012B-6E49-3438-6C10-D77FEB5DE74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6514" t="12758" r="10283" b="18515"/>
          <a:stretch/>
        </p:blipFill>
        <p:spPr>
          <a:xfrm>
            <a:off x="1549529" y="2137845"/>
            <a:ext cx="2577968" cy="39626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B2885343-F6D3-416D-3184-FD334E56CD1D}"/>
              </a:ext>
            </a:extLst>
          </p:cNvPr>
          <p:cNvSpPr txBox="1"/>
          <p:nvPr/>
        </p:nvSpPr>
        <p:spPr>
          <a:xfrm>
            <a:off x="76197" y="3876329"/>
            <a:ext cx="1520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954517AF-AB0E-3DAB-502E-69037551899A}"/>
              </a:ext>
            </a:extLst>
          </p:cNvPr>
          <p:cNvSpPr txBox="1"/>
          <p:nvPr/>
        </p:nvSpPr>
        <p:spPr>
          <a:xfrm>
            <a:off x="76197" y="2978639"/>
            <a:ext cx="1558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DEEC377-D1EE-ED3F-E946-473214CF20D5}"/>
              </a:ext>
            </a:extLst>
          </p:cNvPr>
          <p:cNvSpPr txBox="1"/>
          <p:nvPr/>
        </p:nvSpPr>
        <p:spPr>
          <a:xfrm>
            <a:off x="80686" y="2180006"/>
            <a:ext cx="1558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01A73DB-2DE4-746F-75D0-E7A3DAA6F6AB}"/>
              </a:ext>
            </a:extLst>
          </p:cNvPr>
          <p:cNvSpPr txBox="1"/>
          <p:nvPr/>
        </p:nvSpPr>
        <p:spPr>
          <a:xfrm rot="16200000">
            <a:off x="902868" y="5310487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33B7BBA-47B5-E0D1-D7D2-F1841A9ED648}"/>
              </a:ext>
            </a:extLst>
          </p:cNvPr>
          <p:cNvSpPr txBox="1"/>
          <p:nvPr/>
        </p:nvSpPr>
        <p:spPr>
          <a:xfrm rot="16200000">
            <a:off x="1370713" y="5310487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Cl</a:t>
            </a:r>
            <a:r>
              <a:rPr lang="en-US" altLang="zh-CN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9A02332-70B9-C587-D5BE-2B3309E5B5CD}"/>
              </a:ext>
            </a:extLst>
          </p:cNvPr>
          <p:cNvSpPr txBox="1"/>
          <p:nvPr/>
        </p:nvSpPr>
        <p:spPr>
          <a:xfrm rot="16200000">
            <a:off x="1838558" y="5310487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4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C24F401-F56C-20B8-C417-193F7F3F8C32}"/>
              </a:ext>
            </a:extLst>
          </p:cNvPr>
          <p:cNvSpPr txBox="1"/>
          <p:nvPr/>
        </p:nvSpPr>
        <p:spPr>
          <a:xfrm rot="16200000">
            <a:off x="2306403" y="5310488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8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7B4B8814-2B25-18EB-7547-F5483B6C1A45}"/>
              </a:ext>
            </a:extLst>
          </p:cNvPr>
          <p:cNvSpPr txBox="1"/>
          <p:nvPr/>
        </p:nvSpPr>
        <p:spPr>
          <a:xfrm rot="16200000">
            <a:off x="2637695" y="5447039"/>
            <a:ext cx="2105567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16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08AA31A4-2F02-84BC-04EF-E229418F86A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00330" y="3713315"/>
            <a:ext cx="3191611" cy="712847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A92B42C8-0DEB-D2B5-EA67-C49886253DD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72871" y="2851500"/>
            <a:ext cx="3019070" cy="826914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554F92B7-2345-C585-D80C-415A1E0801D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748108" y="1877344"/>
            <a:ext cx="2970196" cy="90726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062DB4A6-7B7F-FA0D-7D96-C6D5888C419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206194" y="2784604"/>
            <a:ext cx="3191611" cy="821199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08263312-ED20-B137-4DE3-2D55FE312A0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206194" y="1973028"/>
            <a:ext cx="3176332" cy="715891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C8290BBF-B0FB-A869-D472-388AA448487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206194" y="3714012"/>
            <a:ext cx="3198938" cy="493007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62DCE93F-41DA-4687-DA49-C9768D61C6A9}"/>
              </a:ext>
            </a:extLst>
          </p:cNvPr>
          <p:cNvSpPr txBox="1"/>
          <p:nvPr/>
        </p:nvSpPr>
        <p:spPr>
          <a:xfrm rot="16200000">
            <a:off x="4253981" y="5310486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68752016-9E6B-D7D2-B3B7-5B64E29CE2B8}"/>
              </a:ext>
            </a:extLst>
          </p:cNvPr>
          <p:cNvSpPr txBox="1"/>
          <p:nvPr/>
        </p:nvSpPr>
        <p:spPr>
          <a:xfrm rot="16200000">
            <a:off x="4721826" y="5310486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Cl</a:t>
            </a:r>
            <a:r>
              <a:rPr lang="en-US" altLang="zh-CN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4C6C8D27-2CFB-5C8C-6445-356BB7552F47}"/>
              </a:ext>
            </a:extLst>
          </p:cNvPr>
          <p:cNvSpPr txBox="1"/>
          <p:nvPr/>
        </p:nvSpPr>
        <p:spPr>
          <a:xfrm rot="16200000">
            <a:off x="5189671" y="5310486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4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401C869-BB5B-152C-64BB-17D0E409B3D0}"/>
              </a:ext>
            </a:extLst>
          </p:cNvPr>
          <p:cNvSpPr txBox="1"/>
          <p:nvPr/>
        </p:nvSpPr>
        <p:spPr>
          <a:xfrm rot="16200000">
            <a:off x="5657516" y="5310487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8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D39B88C-CC39-FDDE-B486-DF408EF50384}"/>
              </a:ext>
            </a:extLst>
          </p:cNvPr>
          <p:cNvSpPr txBox="1"/>
          <p:nvPr/>
        </p:nvSpPr>
        <p:spPr>
          <a:xfrm rot="16200000">
            <a:off x="5988808" y="5447038"/>
            <a:ext cx="2105567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16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11D5291-3859-4215-C156-C01B1EFD5FA6}"/>
              </a:ext>
            </a:extLst>
          </p:cNvPr>
          <p:cNvSpPr txBox="1"/>
          <p:nvPr/>
        </p:nvSpPr>
        <p:spPr>
          <a:xfrm rot="16200000">
            <a:off x="7922351" y="5310485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5594559-CF7B-CE58-15F4-8EF28A1E42A6}"/>
              </a:ext>
            </a:extLst>
          </p:cNvPr>
          <p:cNvSpPr txBox="1"/>
          <p:nvPr/>
        </p:nvSpPr>
        <p:spPr>
          <a:xfrm rot="16200000">
            <a:off x="8390196" y="5310485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Cl</a:t>
            </a:r>
            <a:r>
              <a:rPr lang="en-US" altLang="zh-CN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D2F820ED-A8AD-5170-0EBD-6541CCA8353C}"/>
              </a:ext>
            </a:extLst>
          </p:cNvPr>
          <p:cNvSpPr txBox="1"/>
          <p:nvPr/>
        </p:nvSpPr>
        <p:spPr>
          <a:xfrm rot="16200000">
            <a:off x="8858041" y="5310485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4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764CA20-7722-6974-AFD8-C83E08A6B8DB}"/>
              </a:ext>
            </a:extLst>
          </p:cNvPr>
          <p:cNvSpPr txBox="1"/>
          <p:nvPr/>
        </p:nvSpPr>
        <p:spPr>
          <a:xfrm rot="16200000">
            <a:off x="9325886" y="5310486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8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5DDCFC6-D8CE-75CC-8474-AA269414FE91}"/>
              </a:ext>
            </a:extLst>
          </p:cNvPr>
          <p:cNvSpPr txBox="1"/>
          <p:nvPr/>
        </p:nvSpPr>
        <p:spPr>
          <a:xfrm rot="16200000">
            <a:off x="9657178" y="5447037"/>
            <a:ext cx="2105567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160mg/m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57E877AE-912F-722D-311D-714B5EA0376E}"/>
              </a:ext>
            </a:extLst>
          </p:cNvPr>
          <p:cNvSpPr txBox="1"/>
          <p:nvPr/>
        </p:nvSpPr>
        <p:spPr>
          <a:xfrm>
            <a:off x="2520104" y="1423130"/>
            <a:ext cx="6238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1st</a:t>
            </a:r>
            <a:endParaRPr lang="zh-CN" altLang="en-US" sz="2800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780D1174-13DB-2AC5-BC84-C9A3F4B49754}"/>
              </a:ext>
            </a:extLst>
          </p:cNvPr>
          <p:cNvSpPr txBox="1"/>
          <p:nvPr/>
        </p:nvSpPr>
        <p:spPr>
          <a:xfrm>
            <a:off x="5932553" y="1423130"/>
            <a:ext cx="7649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2nd</a:t>
            </a:r>
            <a:endParaRPr lang="zh-CN" altLang="en-US" sz="2800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0AA3AB2C-615B-F6FF-DED1-0FAAFD3910B7}"/>
              </a:ext>
            </a:extLst>
          </p:cNvPr>
          <p:cNvSpPr txBox="1"/>
          <p:nvPr/>
        </p:nvSpPr>
        <p:spPr>
          <a:xfrm>
            <a:off x="9510911" y="1423130"/>
            <a:ext cx="7232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3rd</a:t>
            </a:r>
            <a:endParaRPr lang="zh-CN" altLang="en-US" sz="2800" dirty="0"/>
          </a:p>
        </p:txBody>
      </p:sp>
    </p:spTree>
    <p:extLst>
      <p:ext uri="{BB962C8B-B14F-4D97-AF65-F5344CB8AC3E}">
        <p14:creationId xmlns:p14="http://schemas.microsoft.com/office/powerpoint/2010/main" val="5835552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68B7BD63-ECF2-4110-B05B-9323498894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8889" y="1094913"/>
            <a:ext cx="2549096" cy="3630292"/>
          </a:xfrm>
          <a:prstGeom prst="rect">
            <a:avLst/>
          </a:prstGeom>
        </p:spPr>
      </p:pic>
      <p:grpSp>
        <p:nvGrpSpPr>
          <p:cNvPr id="11" name="组合 10">
            <a:extLst>
              <a:ext uri="{FF2B5EF4-FFF2-40B4-BE49-F238E27FC236}">
                <a16:creationId xmlns:a16="http://schemas.microsoft.com/office/drawing/2014/main" id="{4F5ECF64-0C7F-4F00-B372-E4AD7635A911}"/>
              </a:ext>
            </a:extLst>
          </p:cNvPr>
          <p:cNvGrpSpPr/>
          <p:nvPr/>
        </p:nvGrpSpPr>
        <p:grpSpPr>
          <a:xfrm>
            <a:off x="2666686" y="4615142"/>
            <a:ext cx="1903236" cy="2105567"/>
            <a:chOff x="2666686" y="4615142"/>
            <a:chExt cx="1903236" cy="2105567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47AC9F32-108E-C996-1D51-1D8125A68AEB}"/>
                </a:ext>
              </a:extLst>
            </p:cNvPr>
            <p:cNvSpPr txBox="1"/>
            <p:nvPr/>
          </p:nvSpPr>
          <p:spPr>
            <a:xfrm rot="16200000">
              <a:off x="1935120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493CF7A5-4D89-6DE8-7338-831FB9436B17}"/>
                </a:ext>
              </a:extLst>
            </p:cNvPr>
            <p:cNvSpPr txBox="1"/>
            <p:nvPr/>
          </p:nvSpPr>
          <p:spPr>
            <a:xfrm rot="16200000">
              <a:off x="2318596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Cl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878D0859-D11B-0E84-393F-AC7E2FC07EF4}"/>
                </a:ext>
              </a:extLst>
            </p:cNvPr>
            <p:cNvSpPr txBox="1"/>
            <p:nvPr/>
          </p:nvSpPr>
          <p:spPr>
            <a:xfrm rot="16200000">
              <a:off x="2702072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4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E1065D4D-7E29-1050-B956-F331D0AD0FF9}"/>
                </a:ext>
              </a:extLst>
            </p:cNvPr>
            <p:cNvSpPr txBox="1"/>
            <p:nvPr/>
          </p:nvSpPr>
          <p:spPr>
            <a:xfrm rot="16200000">
              <a:off x="3085548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8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B55C7301-4A1E-51C3-D570-D1878B6F45EE}"/>
                </a:ext>
              </a:extLst>
            </p:cNvPr>
            <p:cNvSpPr txBox="1"/>
            <p:nvPr/>
          </p:nvSpPr>
          <p:spPr>
            <a:xfrm rot="16200000">
              <a:off x="3332472" y="5483260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6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" name="文本框 7">
            <a:extLst>
              <a:ext uri="{FF2B5EF4-FFF2-40B4-BE49-F238E27FC236}">
                <a16:creationId xmlns:a16="http://schemas.microsoft.com/office/drawing/2014/main" id="{8950DE93-A86C-5CB5-9C7D-B58AF58A4983}"/>
              </a:ext>
            </a:extLst>
          </p:cNvPr>
          <p:cNvSpPr txBox="1"/>
          <p:nvPr/>
        </p:nvSpPr>
        <p:spPr>
          <a:xfrm>
            <a:off x="323748" y="303194"/>
            <a:ext cx="254909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3D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membrane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st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DABFC119-3D90-47E4-BBC7-45C423E54092}"/>
              </a:ext>
            </a:extLst>
          </p:cNvPr>
          <p:cNvSpPr txBox="1"/>
          <p:nvPr/>
        </p:nvSpPr>
        <p:spPr>
          <a:xfrm>
            <a:off x="1045824" y="2837365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AF2CFD80-F4DA-43EE-ACF3-1836DA3624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86366" y="1456488"/>
            <a:ext cx="2339064" cy="3500417"/>
          </a:xfrm>
          <a:prstGeom prst="rect">
            <a:avLst/>
          </a:prstGeom>
        </p:spPr>
      </p:pic>
      <p:grpSp>
        <p:nvGrpSpPr>
          <p:cNvPr id="15" name="组合 14">
            <a:extLst>
              <a:ext uri="{FF2B5EF4-FFF2-40B4-BE49-F238E27FC236}">
                <a16:creationId xmlns:a16="http://schemas.microsoft.com/office/drawing/2014/main" id="{3EBE6006-2BA8-4F0A-AA30-202952AA6E7F}"/>
              </a:ext>
            </a:extLst>
          </p:cNvPr>
          <p:cNvGrpSpPr/>
          <p:nvPr/>
        </p:nvGrpSpPr>
        <p:grpSpPr>
          <a:xfrm>
            <a:off x="6604280" y="4615143"/>
            <a:ext cx="1903236" cy="2105567"/>
            <a:chOff x="2666686" y="4615142"/>
            <a:chExt cx="1903236" cy="2105567"/>
          </a:xfrm>
        </p:grpSpPr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B5FE7687-358F-4BC5-A2A1-E6FAD71FC63C}"/>
                </a:ext>
              </a:extLst>
            </p:cNvPr>
            <p:cNvSpPr txBox="1"/>
            <p:nvPr/>
          </p:nvSpPr>
          <p:spPr>
            <a:xfrm rot="16200000">
              <a:off x="1935120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DD92B41A-1B03-4893-A1A0-B0E7B19DD470}"/>
                </a:ext>
              </a:extLst>
            </p:cNvPr>
            <p:cNvSpPr txBox="1"/>
            <p:nvPr/>
          </p:nvSpPr>
          <p:spPr>
            <a:xfrm rot="16200000">
              <a:off x="2318596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Cl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E99A2B17-FFA0-4DA1-BE71-A508883A2198}"/>
                </a:ext>
              </a:extLst>
            </p:cNvPr>
            <p:cNvSpPr txBox="1"/>
            <p:nvPr/>
          </p:nvSpPr>
          <p:spPr>
            <a:xfrm rot="16200000">
              <a:off x="2702072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4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3559F5C3-942E-49E3-8496-40302745FA64}"/>
                </a:ext>
              </a:extLst>
            </p:cNvPr>
            <p:cNvSpPr txBox="1"/>
            <p:nvPr/>
          </p:nvSpPr>
          <p:spPr>
            <a:xfrm rot="16200000">
              <a:off x="3085548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8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C95111BC-1420-4A09-8E94-018609BF4760}"/>
                </a:ext>
              </a:extLst>
            </p:cNvPr>
            <p:cNvSpPr txBox="1"/>
            <p:nvPr/>
          </p:nvSpPr>
          <p:spPr>
            <a:xfrm rot="16200000">
              <a:off x="3332472" y="5483260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6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文本框 20">
            <a:extLst>
              <a:ext uri="{FF2B5EF4-FFF2-40B4-BE49-F238E27FC236}">
                <a16:creationId xmlns:a16="http://schemas.microsoft.com/office/drawing/2014/main" id="{A26B9159-6B12-45BB-B8B5-CDD80F0215F1}"/>
              </a:ext>
            </a:extLst>
          </p:cNvPr>
          <p:cNvSpPr txBox="1"/>
          <p:nvPr/>
        </p:nvSpPr>
        <p:spPr>
          <a:xfrm>
            <a:off x="5270758" y="3326275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781504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图片 29">
            <a:extLst>
              <a:ext uri="{FF2B5EF4-FFF2-40B4-BE49-F238E27FC236}">
                <a16:creationId xmlns:a16="http://schemas.microsoft.com/office/drawing/2014/main" id="{DB91DB8E-F80B-4EFB-8227-AFEF0A4B02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29981" y="953275"/>
            <a:ext cx="2557311" cy="3552774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9524E0D2-4AD4-7081-D39F-F3CFE5CB5740}"/>
              </a:ext>
            </a:extLst>
          </p:cNvPr>
          <p:cNvSpPr txBox="1"/>
          <p:nvPr/>
        </p:nvSpPr>
        <p:spPr>
          <a:xfrm>
            <a:off x="625764" y="447964"/>
            <a:ext cx="254909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FIG.7B</a:t>
            </a:r>
          </a:p>
          <a:p>
            <a:r>
              <a:rPr lang="en-US" altLang="zh-CN" dirty="0"/>
              <a:t>Full membrane</a:t>
            </a:r>
          </a:p>
          <a:p>
            <a:r>
              <a:rPr lang="en-US" altLang="zh-CN" dirty="0"/>
              <a:t>1st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A5472F0E-CEDC-4F5A-804D-388F1EAA64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41557" y="1371313"/>
            <a:ext cx="2385698" cy="3200688"/>
          </a:xfrm>
          <a:prstGeom prst="rect">
            <a:avLst/>
          </a:prstGeom>
        </p:spPr>
      </p:pic>
      <p:grpSp>
        <p:nvGrpSpPr>
          <p:cNvPr id="10" name="组合 9">
            <a:extLst>
              <a:ext uri="{FF2B5EF4-FFF2-40B4-BE49-F238E27FC236}">
                <a16:creationId xmlns:a16="http://schemas.microsoft.com/office/drawing/2014/main" id="{D1FA00C3-4592-489A-BD98-FA0231659EC5}"/>
              </a:ext>
            </a:extLst>
          </p:cNvPr>
          <p:cNvGrpSpPr/>
          <p:nvPr/>
        </p:nvGrpSpPr>
        <p:grpSpPr>
          <a:xfrm>
            <a:off x="1634434" y="4578921"/>
            <a:ext cx="1796094" cy="2105567"/>
            <a:chOff x="1634434" y="4578921"/>
            <a:chExt cx="1796094" cy="2105567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8FBDDAD2-D3BD-4D58-834C-BB12DA4BDD80}"/>
                </a:ext>
              </a:extLst>
            </p:cNvPr>
            <p:cNvSpPr txBox="1"/>
            <p:nvPr/>
          </p:nvSpPr>
          <p:spPr>
            <a:xfrm rot="16200000">
              <a:off x="90286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101BB1FF-E08B-443B-BEF7-6B7AEB4082DE}"/>
                </a:ext>
              </a:extLst>
            </p:cNvPr>
            <p:cNvSpPr txBox="1"/>
            <p:nvPr/>
          </p:nvSpPr>
          <p:spPr>
            <a:xfrm rot="16200000">
              <a:off x="125955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Cl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EAD4B63B-F987-4230-93F2-5917F35A3E38}"/>
                </a:ext>
              </a:extLst>
            </p:cNvPr>
            <p:cNvSpPr txBox="1"/>
            <p:nvPr/>
          </p:nvSpPr>
          <p:spPr>
            <a:xfrm rot="16200000">
              <a:off x="161624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4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79C96ECC-3048-4A26-8393-B277CA90E10D}"/>
                </a:ext>
              </a:extLst>
            </p:cNvPr>
            <p:cNvSpPr txBox="1"/>
            <p:nvPr/>
          </p:nvSpPr>
          <p:spPr>
            <a:xfrm rot="16200000">
              <a:off x="1972938" y="5310488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8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AE750477-C81B-4AF0-9EA7-D681DFBA9804}"/>
                </a:ext>
              </a:extLst>
            </p:cNvPr>
            <p:cNvSpPr txBox="1"/>
            <p:nvPr/>
          </p:nvSpPr>
          <p:spPr>
            <a:xfrm rot="16200000">
              <a:off x="2193078" y="5447039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6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2" name="图片 11">
            <a:extLst>
              <a:ext uri="{FF2B5EF4-FFF2-40B4-BE49-F238E27FC236}">
                <a16:creationId xmlns:a16="http://schemas.microsoft.com/office/drawing/2014/main" id="{8BEF27CA-5636-44D1-BE82-145E5362554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23885" y="1371313"/>
            <a:ext cx="2608761" cy="3147697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130571E7-D87D-44A4-8473-B951F3710847}"/>
              </a:ext>
            </a:extLst>
          </p:cNvPr>
          <p:cNvSpPr txBox="1"/>
          <p:nvPr/>
        </p:nvSpPr>
        <p:spPr>
          <a:xfrm>
            <a:off x="3679372" y="1832959"/>
            <a:ext cx="1558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2E7E78B-8B10-4F22-A0E0-8EDE3168A527}"/>
              </a:ext>
            </a:extLst>
          </p:cNvPr>
          <p:cNvSpPr txBox="1"/>
          <p:nvPr/>
        </p:nvSpPr>
        <p:spPr>
          <a:xfrm>
            <a:off x="172965" y="1832959"/>
            <a:ext cx="1558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F27F3AC0-E143-40C2-8AB2-8BEB6027B703}"/>
              </a:ext>
            </a:extLst>
          </p:cNvPr>
          <p:cNvGrpSpPr/>
          <p:nvPr/>
        </p:nvGrpSpPr>
        <p:grpSpPr>
          <a:xfrm>
            <a:off x="5150819" y="4519010"/>
            <a:ext cx="1796094" cy="2105567"/>
            <a:chOff x="1634434" y="4578921"/>
            <a:chExt cx="1796094" cy="2105567"/>
          </a:xfrm>
        </p:grpSpPr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78DC7837-7052-4DA8-8AFA-2293FA62BA2A}"/>
                </a:ext>
              </a:extLst>
            </p:cNvPr>
            <p:cNvSpPr txBox="1"/>
            <p:nvPr/>
          </p:nvSpPr>
          <p:spPr>
            <a:xfrm rot="16200000">
              <a:off x="90286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5C24C752-DCD6-4316-9247-C53FAEB2E262}"/>
                </a:ext>
              </a:extLst>
            </p:cNvPr>
            <p:cNvSpPr txBox="1"/>
            <p:nvPr/>
          </p:nvSpPr>
          <p:spPr>
            <a:xfrm rot="16200000">
              <a:off x="125955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Cl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389796AE-5FD6-4AF2-A246-8D6AC60EB50D}"/>
                </a:ext>
              </a:extLst>
            </p:cNvPr>
            <p:cNvSpPr txBox="1"/>
            <p:nvPr/>
          </p:nvSpPr>
          <p:spPr>
            <a:xfrm rot="16200000">
              <a:off x="161624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4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C0244C27-7BE5-457A-8B92-2B810E845663}"/>
                </a:ext>
              </a:extLst>
            </p:cNvPr>
            <p:cNvSpPr txBox="1"/>
            <p:nvPr/>
          </p:nvSpPr>
          <p:spPr>
            <a:xfrm rot="16200000">
              <a:off x="1972938" y="5310488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8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EBC83FA1-3DB7-4A0B-8D46-02775E5AEC8E}"/>
                </a:ext>
              </a:extLst>
            </p:cNvPr>
            <p:cNvSpPr txBox="1"/>
            <p:nvPr/>
          </p:nvSpPr>
          <p:spPr>
            <a:xfrm rot="16200000">
              <a:off x="2193078" y="5447039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6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" name="文本框 22">
            <a:extLst>
              <a:ext uri="{FF2B5EF4-FFF2-40B4-BE49-F238E27FC236}">
                <a16:creationId xmlns:a16="http://schemas.microsoft.com/office/drawing/2014/main" id="{55707170-0C1F-4485-9CAB-03CCE3B4B383}"/>
              </a:ext>
            </a:extLst>
          </p:cNvPr>
          <p:cNvSpPr txBox="1"/>
          <p:nvPr/>
        </p:nvSpPr>
        <p:spPr>
          <a:xfrm>
            <a:off x="7331656" y="3059668"/>
            <a:ext cx="1520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6E352241-68B8-47C3-A524-546661C332FD}"/>
              </a:ext>
            </a:extLst>
          </p:cNvPr>
          <p:cNvGrpSpPr/>
          <p:nvPr/>
        </p:nvGrpSpPr>
        <p:grpSpPr>
          <a:xfrm>
            <a:off x="8667202" y="4506050"/>
            <a:ext cx="1796094" cy="2105567"/>
            <a:chOff x="1634434" y="4578921"/>
            <a:chExt cx="1796094" cy="2105567"/>
          </a:xfrm>
        </p:grpSpPr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3510D284-A7F2-4712-9694-9ADBD3B24C3F}"/>
                </a:ext>
              </a:extLst>
            </p:cNvPr>
            <p:cNvSpPr txBox="1"/>
            <p:nvPr/>
          </p:nvSpPr>
          <p:spPr>
            <a:xfrm rot="16200000">
              <a:off x="90286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B65584F2-CD78-4D4F-91F1-997CDCFFE0E5}"/>
                </a:ext>
              </a:extLst>
            </p:cNvPr>
            <p:cNvSpPr txBox="1"/>
            <p:nvPr/>
          </p:nvSpPr>
          <p:spPr>
            <a:xfrm rot="16200000">
              <a:off x="125955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Cl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C56A17BC-5ACE-499F-A299-9C7DF8FECACE}"/>
                </a:ext>
              </a:extLst>
            </p:cNvPr>
            <p:cNvSpPr txBox="1"/>
            <p:nvPr/>
          </p:nvSpPr>
          <p:spPr>
            <a:xfrm rot="16200000">
              <a:off x="161624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4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A7527D61-9852-44E8-B546-370C6B60023B}"/>
                </a:ext>
              </a:extLst>
            </p:cNvPr>
            <p:cNvSpPr txBox="1"/>
            <p:nvPr/>
          </p:nvSpPr>
          <p:spPr>
            <a:xfrm rot="16200000">
              <a:off x="1972938" y="5310488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8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87B1FA9A-AB87-481E-828E-5B32D0993F88}"/>
                </a:ext>
              </a:extLst>
            </p:cNvPr>
            <p:cNvSpPr txBox="1"/>
            <p:nvPr/>
          </p:nvSpPr>
          <p:spPr>
            <a:xfrm rot="16200000">
              <a:off x="2193078" y="5447039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6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8125706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524E0D2-4AD4-7081-D39F-F3CFE5CB5740}"/>
              </a:ext>
            </a:extLst>
          </p:cNvPr>
          <p:cNvSpPr txBox="1"/>
          <p:nvPr/>
        </p:nvSpPr>
        <p:spPr>
          <a:xfrm>
            <a:off x="625764" y="447964"/>
            <a:ext cx="254909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FIG.7B</a:t>
            </a:r>
          </a:p>
          <a:p>
            <a:r>
              <a:rPr lang="en-US" altLang="zh-CN" dirty="0"/>
              <a:t>Full membrane</a:t>
            </a:r>
          </a:p>
          <a:p>
            <a:r>
              <a:rPr lang="en-US" altLang="zh-CN" dirty="0"/>
              <a:t>2nd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9DEE1E8-52EA-4008-9CBD-AF9BF99C78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3936" y="1504472"/>
            <a:ext cx="2458188" cy="3026644"/>
          </a:xfrm>
          <a:prstGeom prst="rect">
            <a:avLst/>
          </a:prstGeom>
        </p:spPr>
      </p:pic>
      <p:grpSp>
        <p:nvGrpSpPr>
          <p:cNvPr id="5" name="组合 4">
            <a:extLst>
              <a:ext uri="{FF2B5EF4-FFF2-40B4-BE49-F238E27FC236}">
                <a16:creationId xmlns:a16="http://schemas.microsoft.com/office/drawing/2014/main" id="{1CDFF836-DB34-4AA8-A1F4-B21078ECDC1D}"/>
              </a:ext>
            </a:extLst>
          </p:cNvPr>
          <p:cNvGrpSpPr/>
          <p:nvPr/>
        </p:nvGrpSpPr>
        <p:grpSpPr>
          <a:xfrm>
            <a:off x="1900312" y="4752433"/>
            <a:ext cx="1796094" cy="2105567"/>
            <a:chOff x="1634434" y="4578921"/>
            <a:chExt cx="1796094" cy="2105567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FE493511-2225-4FF8-9DE6-5866958EFE2C}"/>
                </a:ext>
              </a:extLst>
            </p:cNvPr>
            <p:cNvSpPr txBox="1"/>
            <p:nvPr/>
          </p:nvSpPr>
          <p:spPr>
            <a:xfrm rot="16200000">
              <a:off x="90286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08C565DD-8897-4CBD-90C3-0C31BE3529A0}"/>
                </a:ext>
              </a:extLst>
            </p:cNvPr>
            <p:cNvSpPr txBox="1"/>
            <p:nvPr/>
          </p:nvSpPr>
          <p:spPr>
            <a:xfrm rot="16200000">
              <a:off x="125955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Cl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6BB7FDD9-9E1C-4958-A080-47D32F60BD05}"/>
                </a:ext>
              </a:extLst>
            </p:cNvPr>
            <p:cNvSpPr txBox="1"/>
            <p:nvPr/>
          </p:nvSpPr>
          <p:spPr>
            <a:xfrm rot="16200000">
              <a:off x="161624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4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DA068D1B-9282-41F0-81E1-0260BDB180A3}"/>
                </a:ext>
              </a:extLst>
            </p:cNvPr>
            <p:cNvSpPr txBox="1"/>
            <p:nvPr/>
          </p:nvSpPr>
          <p:spPr>
            <a:xfrm rot="16200000">
              <a:off x="1972938" y="5310488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8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A5D8FC95-44C6-4304-BB0A-7BCDE8AEF906}"/>
                </a:ext>
              </a:extLst>
            </p:cNvPr>
            <p:cNvSpPr txBox="1"/>
            <p:nvPr/>
          </p:nvSpPr>
          <p:spPr>
            <a:xfrm rot="16200000">
              <a:off x="2193078" y="5447039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6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文本框 12">
            <a:extLst>
              <a:ext uri="{FF2B5EF4-FFF2-40B4-BE49-F238E27FC236}">
                <a16:creationId xmlns:a16="http://schemas.microsoft.com/office/drawing/2014/main" id="{D4547551-A358-4089-9088-C68B66E4DB43}"/>
              </a:ext>
            </a:extLst>
          </p:cNvPr>
          <p:cNvSpPr txBox="1"/>
          <p:nvPr/>
        </p:nvSpPr>
        <p:spPr>
          <a:xfrm>
            <a:off x="248466" y="2235630"/>
            <a:ext cx="1558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B5DC4567-69C2-4BEE-8BB1-B6D477D79EF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49177"/>
          <a:stretch/>
        </p:blipFill>
        <p:spPr>
          <a:xfrm>
            <a:off x="4866906" y="1504472"/>
            <a:ext cx="2458188" cy="3159807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A3AA3877-6FCB-4040-A4A5-4E98D69B63F5}"/>
              </a:ext>
            </a:extLst>
          </p:cNvPr>
          <p:cNvSpPr txBox="1"/>
          <p:nvPr/>
        </p:nvSpPr>
        <p:spPr>
          <a:xfrm>
            <a:off x="3956208" y="2235630"/>
            <a:ext cx="1558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6019C366-5946-428B-B5C1-77B72757092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9345"/>
          <a:stretch/>
        </p:blipFill>
        <p:spPr>
          <a:xfrm>
            <a:off x="8609995" y="1948985"/>
            <a:ext cx="2346573" cy="2960030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E9F43642-DA1C-4260-812C-793FF47FC523}"/>
              </a:ext>
            </a:extLst>
          </p:cNvPr>
          <p:cNvSpPr txBox="1"/>
          <p:nvPr/>
        </p:nvSpPr>
        <p:spPr>
          <a:xfrm>
            <a:off x="7325094" y="3429000"/>
            <a:ext cx="1520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9C5340D1-1FD7-4D8B-91AB-930543626104}"/>
              </a:ext>
            </a:extLst>
          </p:cNvPr>
          <p:cNvGrpSpPr/>
          <p:nvPr/>
        </p:nvGrpSpPr>
        <p:grpSpPr>
          <a:xfrm>
            <a:off x="5197953" y="4752432"/>
            <a:ext cx="1796094" cy="2105567"/>
            <a:chOff x="1634434" y="4578921"/>
            <a:chExt cx="1796094" cy="2105567"/>
          </a:xfrm>
        </p:grpSpPr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27509FB0-F8D0-4950-A43D-C61255DCED20}"/>
                </a:ext>
              </a:extLst>
            </p:cNvPr>
            <p:cNvSpPr txBox="1"/>
            <p:nvPr/>
          </p:nvSpPr>
          <p:spPr>
            <a:xfrm rot="16200000">
              <a:off x="90286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45439272-E49B-4CE0-A29D-A757461D5B33}"/>
                </a:ext>
              </a:extLst>
            </p:cNvPr>
            <p:cNvSpPr txBox="1"/>
            <p:nvPr/>
          </p:nvSpPr>
          <p:spPr>
            <a:xfrm rot="16200000">
              <a:off x="125955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Cl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E8161A47-B14B-47D5-86A7-18394E67D436}"/>
                </a:ext>
              </a:extLst>
            </p:cNvPr>
            <p:cNvSpPr txBox="1"/>
            <p:nvPr/>
          </p:nvSpPr>
          <p:spPr>
            <a:xfrm rot="16200000">
              <a:off x="161624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4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4E435F3C-45CC-48FA-8D25-40F711336168}"/>
                </a:ext>
              </a:extLst>
            </p:cNvPr>
            <p:cNvSpPr txBox="1"/>
            <p:nvPr/>
          </p:nvSpPr>
          <p:spPr>
            <a:xfrm rot="16200000">
              <a:off x="1972938" y="5310488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8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D3DA7F82-7633-4D0B-AA7D-6F2926390CD7}"/>
                </a:ext>
              </a:extLst>
            </p:cNvPr>
            <p:cNvSpPr txBox="1"/>
            <p:nvPr/>
          </p:nvSpPr>
          <p:spPr>
            <a:xfrm rot="16200000">
              <a:off x="2193078" y="5447039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6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" name="组合 27">
            <a:extLst>
              <a:ext uri="{FF2B5EF4-FFF2-40B4-BE49-F238E27FC236}">
                <a16:creationId xmlns:a16="http://schemas.microsoft.com/office/drawing/2014/main" id="{02B56ADC-4CCF-4B80-92EB-A2A8F03B8F1D}"/>
              </a:ext>
            </a:extLst>
          </p:cNvPr>
          <p:cNvGrpSpPr/>
          <p:nvPr/>
        </p:nvGrpSpPr>
        <p:grpSpPr>
          <a:xfrm>
            <a:off x="8885234" y="4752433"/>
            <a:ext cx="1796094" cy="2105567"/>
            <a:chOff x="1634434" y="4578921"/>
            <a:chExt cx="1796094" cy="2105567"/>
          </a:xfrm>
        </p:grpSpPr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0D2FFF5B-D281-4D7D-8B8C-8B28E64397EF}"/>
                </a:ext>
              </a:extLst>
            </p:cNvPr>
            <p:cNvSpPr txBox="1"/>
            <p:nvPr/>
          </p:nvSpPr>
          <p:spPr>
            <a:xfrm rot="16200000">
              <a:off x="90286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0DC92CDC-FC55-4192-A8E9-ED4CC579B3B2}"/>
                </a:ext>
              </a:extLst>
            </p:cNvPr>
            <p:cNvSpPr txBox="1"/>
            <p:nvPr/>
          </p:nvSpPr>
          <p:spPr>
            <a:xfrm rot="16200000">
              <a:off x="125955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Cl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FFFF4B0A-EFB8-436A-83C9-BEE4814DF348}"/>
                </a:ext>
              </a:extLst>
            </p:cNvPr>
            <p:cNvSpPr txBox="1"/>
            <p:nvPr/>
          </p:nvSpPr>
          <p:spPr>
            <a:xfrm rot="16200000">
              <a:off x="161624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4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C6531D8F-B0B1-4E29-AC9F-B67EDC9C53E6}"/>
                </a:ext>
              </a:extLst>
            </p:cNvPr>
            <p:cNvSpPr txBox="1"/>
            <p:nvPr/>
          </p:nvSpPr>
          <p:spPr>
            <a:xfrm rot="16200000">
              <a:off x="1972938" y="5310488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8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1D2C116C-D570-425C-8E34-2B0474C898C3}"/>
                </a:ext>
              </a:extLst>
            </p:cNvPr>
            <p:cNvSpPr txBox="1"/>
            <p:nvPr/>
          </p:nvSpPr>
          <p:spPr>
            <a:xfrm rot="16200000">
              <a:off x="2193078" y="5447039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6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7170437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524E0D2-4AD4-7081-D39F-F3CFE5CB5740}"/>
              </a:ext>
            </a:extLst>
          </p:cNvPr>
          <p:cNvSpPr txBox="1"/>
          <p:nvPr/>
        </p:nvSpPr>
        <p:spPr>
          <a:xfrm>
            <a:off x="625764" y="447964"/>
            <a:ext cx="254909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FIG.7B</a:t>
            </a:r>
          </a:p>
          <a:p>
            <a:r>
              <a:rPr lang="en-US" altLang="zh-CN" dirty="0"/>
              <a:t>Full membrane</a:t>
            </a:r>
          </a:p>
          <a:p>
            <a:r>
              <a:rPr lang="en-US" altLang="zh-CN" dirty="0"/>
              <a:t>3rd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68994220-03EB-4B80-B45C-10CC27E69C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6750" y="1392923"/>
            <a:ext cx="2334132" cy="3055309"/>
          </a:xfrm>
          <a:prstGeom prst="rect">
            <a:avLst/>
          </a:prstGeom>
        </p:spPr>
      </p:pic>
      <p:grpSp>
        <p:nvGrpSpPr>
          <p:cNvPr id="5" name="组合 4">
            <a:extLst>
              <a:ext uri="{FF2B5EF4-FFF2-40B4-BE49-F238E27FC236}">
                <a16:creationId xmlns:a16="http://schemas.microsoft.com/office/drawing/2014/main" id="{56A59FEE-750F-44AA-A11A-F2210AF978E3}"/>
              </a:ext>
            </a:extLst>
          </p:cNvPr>
          <p:cNvGrpSpPr/>
          <p:nvPr/>
        </p:nvGrpSpPr>
        <p:grpSpPr>
          <a:xfrm>
            <a:off x="1760269" y="4562143"/>
            <a:ext cx="1796094" cy="2105567"/>
            <a:chOff x="1634434" y="4578921"/>
            <a:chExt cx="1796094" cy="2105567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74D46493-D76B-41E0-A442-A02138078069}"/>
                </a:ext>
              </a:extLst>
            </p:cNvPr>
            <p:cNvSpPr txBox="1"/>
            <p:nvPr/>
          </p:nvSpPr>
          <p:spPr>
            <a:xfrm rot="16200000">
              <a:off x="90286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5902B0E9-BAA8-4C67-B5B5-B5C86A2C3790}"/>
                </a:ext>
              </a:extLst>
            </p:cNvPr>
            <p:cNvSpPr txBox="1"/>
            <p:nvPr/>
          </p:nvSpPr>
          <p:spPr>
            <a:xfrm rot="16200000">
              <a:off x="125955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Cl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5ACC8EF2-FCE7-42DA-B9C5-F32100971FAE}"/>
                </a:ext>
              </a:extLst>
            </p:cNvPr>
            <p:cNvSpPr txBox="1"/>
            <p:nvPr/>
          </p:nvSpPr>
          <p:spPr>
            <a:xfrm rot="16200000">
              <a:off x="161624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4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ED5D17F8-0342-4C09-8FB9-A613B6535F4F}"/>
                </a:ext>
              </a:extLst>
            </p:cNvPr>
            <p:cNvSpPr txBox="1"/>
            <p:nvPr/>
          </p:nvSpPr>
          <p:spPr>
            <a:xfrm rot="16200000">
              <a:off x="1972938" y="5310488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8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1ECB6BC5-EF13-4FA1-9860-81D0345731F4}"/>
                </a:ext>
              </a:extLst>
            </p:cNvPr>
            <p:cNvSpPr txBox="1"/>
            <p:nvPr/>
          </p:nvSpPr>
          <p:spPr>
            <a:xfrm rot="16200000">
              <a:off x="2193078" y="5447039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6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文本框 10">
            <a:extLst>
              <a:ext uri="{FF2B5EF4-FFF2-40B4-BE49-F238E27FC236}">
                <a16:creationId xmlns:a16="http://schemas.microsoft.com/office/drawing/2014/main" id="{385AA07A-1B40-4BD6-A612-B6D77ECF1493}"/>
              </a:ext>
            </a:extLst>
          </p:cNvPr>
          <p:cNvSpPr txBox="1"/>
          <p:nvPr/>
        </p:nvSpPr>
        <p:spPr>
          <a:xfrm>
            <a:off x="202032" y="2134962"/>
            <a:ext cx="1558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BB6E51AA-979A-47A9-BBB6-AE43AE9277F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798"/>
          <a:stretch/>
        </p:blipFill>
        <p:spPr>
          <a:xfrm>
            <a:off x="4857748" y="1471349"/>
            <a:ext cx="2476504" cy="3159807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8F51D5E9-650B-4660-A1C4-84B524C06761}"/>
              </a:ext>
            </a:extLst>
          </p:cNvPr>
          <p:cNvSpPr txBox="1"/>
          <p:nvPr/>
        </p:nvSpPr>
        <p:spPr>
          <a:xfrm>
            <a:off x="3838763" y="2151740"/>
            <a:ext cx="1558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8A9BE82E-A3B9-427E-A5D7-4936921D6DA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-1" b="11588"/>
          <a:stretch/>
        </p:blipFill>
        <p:spPr>
          <a:xfrm>
            <a:off x="8458898" y="1536365"/>
            <a:ext cx="2339064" cy="3094792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91FD4C02-1946-4252-BCC9-DFE02CC1297E}"/>
              </a:ext>
            </a:extLst>
          </p:cNvPr>
          <p:cNvSpPr txBox="1"/>
          <p:nvPr/>
        </p:nvSpPr>
        <p:spPr>
          <a:xfrm>
            <a:off x="7274816" y="3353391"/>
            <a:ext cx="1520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2A2C7DD2-32E0-4E33-A323-58F867B797D3}"/>
              </a:ext>
            </a:extLst>
          </p:cNvPr>
          <p:cNvGrpSpPr/>
          <p:nvPr/>
        </p:nvGrpSpPr>
        <p:grpSpPr>
          <a:xfrm>
            <a:off x="5029772" y="4562144"/>
            <a:ext cx="1796094" cy="2105567"/>
            <a:chOff x="1634434" y="4578921"/>
            <a:chExt cx="1796094" cy="2105567"/>
          </a:xfrm>
        </p:grpSpPr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8F1B11FD-2146-40B4-B4ED-D50AB2CE5317}"/>
                </a:ext>
              </a:extLst>
            </p:cNvPr>
            <p:cNvSpPr txBox="1"/>
            <p:nvPr/>
          </p:nvSpPr>
          <p:spPr>
            <a:xfrm rot="16200000">
              <a:off x="90286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FED8CC5C-C5DE-4444-B060-0018FC0A68F1}"/>
                </a:ext>
              </a:extLst>
            </p:cNvPr>
            <p:cNvSpPr txBox="1"/>
            <p:nvPr/>
          </p:nvSpPr>
          <p:spPr>
            <a:xfrm rot="16200000">
              <a:off x="125955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Cl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C84E5F64-F97E-4C22-AB30-1783A696308B}"/>
                </a:ext>
              </a:extLst>
            </p:cNvPr>
            <p:cNvSpPr txBox="1"/>
            <p:nvPr/>
          </p:nvSpPr>
          <p:spPr>
            <a:xfrm rot="16200000">
              <a:off x="161624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4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D2D87098-2050-4E17-8064-BA57826F8B86}"/>
                </a:ext>
              </a:extLst>
            </p:cNvPr>
            <p:cNvSpPr txBox="1"/>
            <p:nvPr/>
          </p:nvSpPr>
          <p:spPr>
            <a:xfrm rot="16200000">
              <a:off x="1972938" y="5310488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8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EEA1FEF7-0336-4A9D-9E65-39E65A8B8C34}"/>
                </a:ext>
              </a:extLst>
            </p:cNvPr>
            <p:cNvSpPr txBox="1"/>
            <p:nvPr/>
          </p:nvSpPr>
          <p:spPr>
            <a:xfrm rot="16200000">
              <a:off x="2193078" y="5447039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6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55BA54BB-4E15-4F5C-8CB6-C685D5829E0A}"/>
              </a:ext>
            </a:extLst>
          </p:cNvPr>
          <p:cNvGrpSpPr/>
          <p:nvPr/>
        </p:nvGrpSpPr>
        <p:grpSpPr>
          <a:xfrm>
            <a:off x="8730383" y="4581185"/>
            <a:ext cx="1796094" cy="2105567"/>
            <a:chOff x="1634434" y="4578921"/>
            <a:chExt cx="1796094" cy="2105567"/>
          </a:xfrm>
        </p:grpSpPr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364CE31C-44A7-4ADD-A072-5A8A97C9696A}"/>
                </a:ext>
              </a:extLst>
            </p:cNvPr>
            <p:cNvSpPr txBox="1"/>
            <p:nvPr/>
          </p:nvSpPr>
          <p:spPr>
            <a:xfrm rot="16200000">
              <a:off x="90286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746444A5-89CA-43D5-A2F2-049EA2E3E038}"/>
                </a:ext>
              </a:extLst>
            </p:cNvPr>
            <p:cNvSpPr txBox="1"/>
            <p:nvPr/>
          </p:nvSpPr>
          <p:spPr>
            <a:xfrm rot="16200000">
              <a:off x="125955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Cl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F5993AF9-896F-45BA-A7A3-2D01D66FBA1D}"/>
                </a:ext>
              </a:extLst>
            </p:cNvPr>
            <p:cNvSpPr txBox="1"/>
            <p:nvPr/>
          </p:nvSpPr>
          <p:spPr>
            <a:xfrm rot="16200000">
              <a:off x="1616248" y="5310487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4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145CF359-5788-4361-A059-B6ED3300466B}"/>
                </a:ext>
              </a:extLst>
            </p:cNvPr>
            <p:cNvSpPr txBox="1"/>
            <p:nvPr/>
          </p:nvSpPr>
          <p:spPr>
            <a:xfrm rot="16200000">
              <a:off x="1972938" y="5310488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8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47A27290-DD41-4FF2-816B-23B120117D01}"/>
                </a:ext>
              </a:extLst>
            </p:cNvPr>
            <p:cNvSpPr txBox="1"/>
            <p:nvPr/>
          </p:nvSpPr>
          <p:spPr>
            <a:xfrm rot="16200000">
              <a:off x="2193078" y="5447039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6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040449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8950DE93-A86C-5CB5-9C7D-B58AF58A4983}"/>
              </a:ext>
            </a:extLst>
          </p:cNvPr>
          <p:cNvSpPr txBox="1"/>
          <p:nvPr/>
        </p:nvSpPr>
        <p:spPr>
          <a:xfrm>
            <a:off x="323748" y="303194"/>
            <a:ext cx="254909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3D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membrane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nd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0018383-F203-43CF-84D8-52B18AC639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4818" y="1477368"/>
            <a:ext cx="2346573" cy="3060392"/>
          </a:xfrm>
          <a:prstGeom prst="rect">
            <a:avLst/>
          </a:prstGeom>
        </p:spPr>
      </p:pic>
      <p:grpSp>
        <p:nvGrpSpPr>
          <p:cNvPr id="5" name="组合 4">
            <a:extLst>
              <a:ext uri="{FF2B5EF4-FFF2-40B4-BE49-F238E27FC236}">
                <a16:creationId xmlns:a16="http://schemas.microsoft.com/office/drawing/2014/main" id="{A5A301E8-87E2-4BDD-9C69-CDE556CC0548}"/>
              </a:ext>
            </a:extLst>
          </p:cNvPr>
          <p:cNvGrpSpPr/>
          <p:nvPr/>
        </p:nvGrpSpPr>
        <p:grpSpPr>
          <a:xfrm>
            <a:off x="2666686" y="4615142"/>
            <a:ext cx="1903236" cy="2105567"/>
            <a:chOff x="2666686" y="4615142"/>
            <a:chExt cx="1903236" cy="2105567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B92DF534-37DC-41E4-92D4-A24B89C9F2E3}"/>
                </a:ext>
              </a:extLst>
            </p:cNvPr>
            <p:cNvSpPr txBox="1"/>
            <p:nvPr/>
          </p:nvSpPr>
          <p:spPr>
            <a:xfrm rot="16200000">
              <a:off x="1935120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E99165D8-80F8-463D-90DA-5733816F29E8}"/>
                </a:ext>
              </a:extLst>
            </p:cNvPr>
            <p:cNvSpPr txBox="1"/>
            <p:nvPr/>
          </p:nvSpPr>
          <p:spPr>
            <a:xfrm rot="16200000">
              <a:off x="2318596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Cl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44032BD1-1712-4E3C-9893-62BEEA8FDA52}"/>
                </a:ext>
              </a:extLst>
            </p:cNvPr>
            <p:cNvSpPr txBox="1"/>
            <p:nvPr/>
          </p:nvSpPr>
          <p:spPr>
            <a:xfrm rot="16200000">
              <a:off x="2702072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4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A7B3A351-0A9C-4338-9AE1-DC95999C048B}"/>
                </a:ext>
              </a:extLst>
            </p:cNvPr>
            <p:cNvSpPr txBox="1"/>
            <p:nvPr/>
          </p:nvSpPr>
          <p:spPr>
            <a:xfrm rot="16200000">
              <a:off x="3085548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8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6EBAD832-5FE0-4C1E-A25D-CFE2D1626671}"/>
                </a:ext>
              </a:extLst>
            </p:cNvPr>
            <p:cNvSpPr txBox="1"/>
            <p:nvPr/>
          </p:nvSpPr>
          <p:spPr>
            <a:xfrm rot="16200000">
              <a:off x="3332472" y="5483260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6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文本框 11">
            <a:extLst>
              <a:ext uri="{FF2B5EF4-FFF2-40B4-BE49-F238E27FC236}">
                <a16:creationId xmlns:a16="http://schemas.microsoft.com/office/drawing/2014/main" id="{763BEB34-C626-4D08-ABB1-2DF575247D6A}"/>
              </a:ext>
            </a:extLst>
          </p:cNvPr>
          <p:cNvSpPr txBox="1"/>
          <p:nvPr/>
        </p:nvSpPr>
        <p:spPr>
          <a:xfrm>
            <a:off x="1087769" y="2677697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6FC17815-C747-499A-816C-DE1EEF5A50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48793" y="1594815"/>
            <a:ext cx="2346573" cy="3265160"/>
          </a:xfrm>
          <a:prstGeom prst="rect">
            <a:avLst/>
          </a:prstGeom>
        </p:spPr>
      </p:pic>
      <p:grpSp>
        <p:nvGrpSpPr>
          <p:cNvPr id="14" name="组合 13">
            <a:extLst>
              <a:ext uri="{FF2B5EF4-FFF2-40B4-BE49-F238E27FC236}">
                <a16:creationId xmlns:a16="http://schemas.microsoft.com/office/drawing/2014/main" id="{58E9E80B-DBE5-4434-B3EF-C5689EE1274C}"/>
              </a:ext>
            </a:extLst>
          </p:cNvPr>
          <p:cNvGrpSpPr/>
          <p:nvPr/>
        </p:nvGrpSpPr>
        <p:grpSpPr>
          <a:xfrm>
            <a:off x="6670462" y="4615143"/>
            <a:ext cx="1903236" cy="2105567"/>
            <a:chOff x="2666686" y="4615142"/>
            <a:chExt cx="1903236" cy="2105567"/>
          </a:xfrm>
        </p:grpSpPr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C15ED688-BD1C-4776-B7CB-FFEF1FF8FA0C}"/>
                </a:ext>
              </a:extLst>
            </p:cNvPr>
            <p:cNvSpPr txBox="1"/>
            <p:nvPr/>
          </p:nvSpPr>
          <p:spPr>
            <a:xfrm rot="16200000">
              <a:off x="1935120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E6EB87CE-4FE8-4110-BCEA-D5E9C90CA17D}"/>
                </a:ext>
              </a:extLst>
            </p:cNvPr>
            <p:cNvSpPr txBox="1"/>
            <p:nvPr/>
          </p:nvSpPr>
          <p:spPr>
            <a:xfrm rot="16200000">
              <a:off x="2318596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Cl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AD0579A6-33DB-4487-B76A-598CC758F42D}"/>
                </a:ext>
              </a:extLst>
            </p:cNvPr>
            <p:cNvSpPr txBox="1"/>
            <p:nvPr/>
          </p:nvSpPr>
          <p:spPr>
            <a:xfrm rot="16200000">
              <a:off x="2702072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4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7123F9B3-D340-4D53-BD1E-B71A9E3620A6}"/>
                </a:ext>
              </a:extLst>
            </p:cNvPr>
            <p:cNvSpPr txBox="1"/>
            <p:nvPr/>
          </p:nvSpPr>
          <p:spPr>
            <a:xfrm rot="16200000">
              <a:off x="3085548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8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878166E3-C997-48FA-A235-E3ADD5EAA47E}"/>
                </a:ext>
              </a:extLst>
            </p:cNvPr>
            <p:cNvSpPr txBox="1"/>
            <p:nvPr/>
          </p:nvSpPr>
          <p:spPr>
            <a:xfrm rot="16200000">
              <a:off x="3332472" y="5483260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6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文本框 19">
            <a:extLst>
              <a:ext uri="{FF2B5EF4-FFF2-40B4-BE49-F238E27FC236}">
                <a16:creationId xmlns:a16="http://schemas.microsoft.com/office/drawing/2014/main" id="{2674F314-3AD1-49CD-8585-EC9751DA60C4}"/>
              </a:ext>
            </a:extLst>
          </p:cNvPr>
          <p:cNvSpPr txBox="1"/>
          <p:nvPr/>
        </p:nvSpPr>
        <p:spPr>
          <a:xfrm>
            <a:off x="5152274" y="3141717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10858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A4D4F59-EFDD-4024-B0D1-4D4A769E4C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8216" y="1428849"/>
            <a:ext cx="2557311" cy="3186293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8950DE93-A86C-5CB5-9C7D-B58AF58A4983}"/>
              </a:ext>
            </a:extLst>
          </p:cNvPr>
          <p:cNvSpPr txBox="1"/>
          <p:nvPr/>
        </p:nvSpPr>
        <p:spPr>
          <a:xfrm>
            <a:off x="323748" y="303194"/>
            <a:ext cx="254909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3D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membrane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rd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945D417E-0C29-4394-8D8B-A02C3978D888}"/>
              </a:ext>
            </a:extLst>
          </p:cNvPr>
          <p:cNvGrpSpPr/>
          <p:nvPr/>
        </p:nvGrpSpPr>
        <p:grpSpPr>
          <a:xfrm>
            <a:off x="2666686" y="4615142"/>
            <a:ext cx="1903236" cy="2105567"/>
            <a:chOff x="2666686" y="4615142"/>
            <a:chExt cx="1903236" cy="2105567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6B7CBEEE-68C7-40D4-82B7-8A5A859D3553}"/>
                </a:ext>
              </a:extLst>
            </p:cNvPr>
            <p:cNvSpPr txBox="1"/>
            <p:nvPr/>
          </p:nvSpPr>
          <p:spPr>
            <a:xfrm rot="16200000">
              <a:off x="1935120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48E40B34-F8FF-4340-BA09-27E61257AD0E}"/>
                </a:ext>
              </a:extLst>
            </p:cNvPr>
            <p:cNvSpPr txBox="1"/>
            <p:nvPr/>
          </p:nvSpPr>
          <p:spPr>
            <a:xfrm rot="16200000">
              <a:off x="2318596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Cl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DD6233BA-3F33-4BC2-8FED-821F10B411A3}"/>
                </a:ext>
              </a:extLst>
            </p:cNvPr>
            <p:cNvSpPr txBox="1"/>
            <p:nvPr/>
          </p:nvSpPr>
          <p:spPr>
            <a:xfrm rot="16200000">
              <a:off x="2702072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4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2F856981-F741-407D-A121-00499206B371}"/>
                </a:ext>
              </a:extLst>
            </p:cNvPr>
            <p:cNvSpPr txBox="1"/>
            <p:nvPr/>
          </p:nvSpPr>
          <p:spPr>
            <a:xfrm rot="16200000">
              <a:off x="3085548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8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6053CA3F-FD61-49FF-B193-0FCA6556A88D}"/>
                </a:ext>
              </a:extLst>
            </p:cNvPr>
            <p:cNvSpPr txBox="1"/>
            <p:nvPr/>
          </p:nvSpPr>
          <p:spPr>
            <a:xfrm rot="16200000">
              <a:off x="3332472" y="5483260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6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文本框 11">
            <a:extLst>
              <a:ext uri="{FF2B5EF4-FFF2-40B4-BE49-F238E27FC236}">
                <a16:creationId xmlns:a16="http://schemas.microsoft.com/office/drawing/2014/main" id="{C8FABAD1-18DA-4869-9014-D39B7D6C5B48}"/>
              </a:ext>
            </a:extLst>
          </p:cNvPr>
          <p:cNvSpPr txBox="1"/>
          <p:nvPr/>
        </p:nvSpPr>
        <p:spPr>
          <a:xfrm>
            <a:off x="1148499" y="2717258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21DA79D9-924A-4FC9-8E30-C06139BD2F6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47989" y="1062368"/>
            <a:ext cx="2557311" cy="3552774"/>
          </a:xfrm>
          <a:prstGeom prst="rect">
            <a:avLst/>
          </a:prstGeom>
        </p:spPr>
      </p:pic>
      <p:grpSp>
        <p:nvGrpSpPr>
          <p:cNvPr id="14" name="组合 13">
            <a:extLst>
              <a:ext uri="{FF2B5EF4-FFF2-40B4-BE49-F238E27FC236}">
                <a16:creationId xmlns:a16="http://schemas.microsoft.com/office/drawing/2014/main" id="{8BD03BC8-FA85-4E3B-A99A-2C6D5082F8A5}"/>
              </a:ext>
            </a:extLst>
          </p:cNvPr>
          <p:cNvGrpSpPr/>
          <p:nvPr/>
        </p:nvGrpSpPr>
        <p:grpSpPr>
          <a:xfrm>
            <a:off x="6847436" y="4560016"/>
            <a:ext cx="1903236" cy="2105567"/>
            <a:chOff x="2666686" y="4615142"/>
            <a:chExt cx="1903236" cy="2105567"/>
          </a:xfrm>
        </p:grpSpPr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55BFD836-9123-4316-A385-BD26CDB283B7}"/>
                </a:ext>
              </a:extLst>
            </p:cNvPr>
            <p:cNvSpPr txBox="1"/>
            <p:nvPr/>
          </p:nvSpPr>
          <p:spPr>
            <a:xfrm rot="16200000">
              <a:off x="1935120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7D57A4F9-5F88-4EE9-B1A6-5DD3531BAA6E}"/>
                </a:ext>
              </a:extLst>
            </p:cNvPr>
            <p:cNvSpPr txBox="1"/>
            <p:nvPr/>
          </p:nvSpPr>
          <p:spPr>
            <a:xfrm rot="16200000">
              <a:off x="2318596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Cl</a:t>
              </a:r>
              <a:r>
                <a:rPr lang="en-US" altLang="zh-CN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F33D6267-8822-4CDD-A48F-9AF139B687E4}"/>
                </a:ext>
              </a:extLst>
            </p:cNvPr>
            <p:cNvSpPr txBox="1"/>
            <p:nvPr/>
          </p:nvSpPr>
          <p:spPr>
            <a:xfrm rot="16200000">
              <a:off x="2702072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4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5F2954EE-5D90-4082-8B2A-5D7832EF76DD}"/>
                </a:ext>
              </a:extLst>
            </p:cNvPr>
            <p:cNvSpPr txBox="1"/>
            <p:nvPr/>
          </p:nvSpPr>
          <p:spPr>
            <a:xfrm rot="16200000">
              <a:off x="3085548" y="5346709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8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FACF7116-F93E-4D99-AD5C-0D4C78466C52}"/>
                </a:ext>
              </a:extLst>
            </p:cNvPr>
            <p:cNvSpPr txBox="1"/>
            <p:nvPr/>
          </p:nvSpPr>
          <p:spPr>
            <a:xfrm rot="16200000">
              <a:off x="3332472" y="5483260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60mg/m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文本框 19">
            <a:extLst>
              <a:ext uri="{FF2B5EF4-FFF2-40B4-BE49-F238E27FC236}">
                <a16:creationId xmlns:a16="http://schemas.microsoft.com/office/drawing/2014/main" id="{D3B6912B-24F3-47B9-8DD1-B7A5D5061480}"/>
              </a:ext>
            </a:extLst>
          </p:cNvPr>
          <p:cNvSpPr txBox="1"/>
          <p:nvPr/>
        </p:nvSpPr>
        <p:spPr>
          <a:xfrm>
            <a:off x="5336906" y="3170480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69823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4803473B-E8E1-AD90-CD2A-C76E7FB11C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52776" y="2751710"/>
            <a:ext cx="4318246" cy="1102815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D0AEE075-7ECE-8273-AEA3-67A1197A51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94866" y="1964106"/>
            <a:ext cx="4034067" cy="787604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9F0A4C1D-E264-EE04-D923-2D157C00F93C}"/>
              </a:ext>
            </a:extLst>
          </p:cNvPr>
          <p:cNvSpPr txBox="1"/>
          <p:nvPr/>
        </p:nvSpPr>
        <p:spPr>
          <a:xfrm>
            <a:off x="323748" y="303194"/>
            <a:ext cx="3281604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B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opped membrane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9D07600-4FB1-55A1-B0AB-B13CCE7050E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5018" y="2938406"/>
            <a:ext cx="3892935" cy="809012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8B6D459B-0CD1-21E6-7A1A-434BCB304A9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511" t="13585" r="5752" b="16866"/>
          <a:stretch/>
        </p:blipFill>
        <p:spPr>
          <a:xfrm>
            <a:off x="1154253" y="2100591"/>
            <a:ext cx="3454463" cy="651119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3BA5EFDD-95EC-74D7-3434-AC567AE476B3}"/>
              </a:ext>
            </a:extLst>
          </p:cNvPr>
          <p:cNvSpPr txBox="1"/>
          <p:nvPr/>
        </p:nvSpPr>
        <p:spPr>
          <a:xfrm>
            <a:off x="26861" y="2271555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23B7E23-8943-443E-A720-8EF4865EBEF5}"/>
              </a:ext>
            </a:extLst>
          </p:cNvPr>
          <p:cNvSpPr txBox="1"/>
          <p:nvPr/>
        </p:nvSpPr>
        <p:spPr>
          <a:xfrm>
            <a:off x="26861" y="3216132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BFB952E2-1AAF-5A33-F451-85ADE6595C6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28933" y="1861821"/>
            <a:ext cx="3793394" cy="889889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7E2915FF-D9A2-A3E1-55DC-6D12EAC6C2E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613112" y="2717490"/>
            <a:ext cx="3318860" cy="846968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6DE4EE14-9B68-5B7A-F046-44851D59D598}"/>
              </a:ext>
            </a:extLst>
          </p:cNvPr>
          <p:cNvSpPr txBox="1"/>
          <p:nvPr/>
        </p:nvSpPr>
        <p:spPr>
          <a:xfrm rot="16200000">
            <a:off x="1011897" y="4631384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BFA2618-9F9A-A7F8-4591-45FCCA48240B}"/>
              </a:ext>
            </a:extLst>
          </p:cNvPr>
          <p:cNvSpPr txBox="1"/>
          <p:nvPr/>
        </p:nvSpPr>
        <p:spPr>
          <a:xfrm rot="16200000">
            <a:off x="1494349" y="4631384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GF-β1</a:t>
            </a:r>
            <a:endParaRPr lang="zh-CN" alt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28DD11E-C48C-FF47-F814-F072EB3C3BD3}"/>
              </a:ext>
            </a:extLst>
          </p:cNvPr>
          <p:cNvSpPr txBox="1"/>
          <p:nvPr/>
        </p:nvSpPr>
        <p:spPr>
          <a:xfrm rot="16200000">
            <a:off x="1976801" y="4631384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0.2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D92E06BA-2780-C97C-5A45-4D0022AC4CB4}"/>
              </a:ext>
            </a:extLst>
          </p:cNvPr>
          <p:cNvSpPr txBox="1"/>
          <p:nvPr/>
        </p:nvSpPr>
        <p:spPr>
          <a:xfrm rot="16200000">
            <a:off x="2459252" y="4631384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0.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FBAACE09-3DA3-B1D8-0422-F25881A6D13B}"/>
              </a:ext>
            </a:extLst>
          </p:cNvPr>
          <p:cNvSpPr txBox="1"/>
          <p:nvPr/>
        </p:nvSpPr>
        <p:spPr>
          <a:xfrm rot="16200000">
            <a:off x="2805151" y="4767936"/>
            <a:ext cx="2105567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1.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CA6A5056-06CB-29A3-8E56-34B72937B8D7}"/>
              </a:ext>
            </a:extLst>
          </p:cNvPr>
          <p:cNvSpPr txBox="1"/>
          <p:nvPr/>
        </p:nvSpPr>
        <p:spPr>
          <a:xfrm rot="16200000">
            <a:off x="4504398" y="4631384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2CB3D9E-3F3D-75A3-D373-46FD07BA90A2}"/>
              </a:ext>
            </a:extLst>
          </p:cNvPr>
          <p:cNvSpPr txBox="1"/>
          <p:nvPr/>
        </p:nvSpPr>
        <p:spPr>
          <a:xfrm rot="16200000">
            <a:off x="4986850" y="4631384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GF-β1</a:t>
            </a:r>
            <a:endParaRPr lang="zh-CN" alt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22A1E3D0-EB9C-E3CE-74BE-914E76738AA7}"/>
              </a:ext>
            </a:extLst>
          </p:cNvPr>
          <p:cNvSpPr txBox="1"/>
          <p:nvPr/>
        </p:nvSpPr>
        <p:spPr>
          <a:xfrm rot="16200000">
            <a:off x="5469302" y="4631384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0.2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5C907D7C-3710-6A4D-0D1C-0C2CA698E15A}"/>
              </a:ext>
            </a:extLst>
          </p:cNvPr>
          <p:cNvSpPr txBox="1"/>
          <p:nvPr/>
        </p:nvSpPr>
        <p:spPr>
          <a:xfrm rot="16200000">
            <a:off x="5951753" y="4631384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0.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E0F0B7A8-660C-3644-9A81-AC012C81DAE6}"/>
              </a:ext>
            </a:extLst>
          </p:cNvPr>
          <p:cNvSpPr txBox="1"/>
          <p:nvPr/>
        </p:nvSpPr>
        <p:spPr>
          <a:xfrm rot="16200000">
            <a:off x="6297652" y="4767936"/>
            <a:ext cx="2105567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1.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48607F5-F312-63A6-2308-7030BEAEA55D}"/>
              </a:ext>
            </a:extLst>
          </p:cNvPr>
          <p:cNvSpPr txBox="1"/>
          <p:nvPr/>
        </p:nvSpPr>
        <p:spPr>
          <a:xfrm rot="16200000">
            <a:off x="8364009" y="4631383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C59F50A-D0E4-917B-4DFB-5B0EA5FDF927}"/>
              </a:ext>
            </a:extLst>
          </p:cNvPr>
          <p:cNvSpPr txBox="1"/>
          <p:nvPr/>
        </p:nvSpPr>
        <p:spPr>
          <a:xfrm rot="16200000">
            <a:off x="8846461" y="4631383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GF-β1</a:t>
            </a:r>
            <a:endParaRPr lang="zh-CN" alt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8920E093-5621-912A-15C3-B1A6D15C766F}"/>
              </a:ext>
            </a:extLst>
          </p:cNvPr>
          <p:cNvSpPr txBox="1"/>
          <p:nvPr/>
        </p:nvSpPr>
        <p:spPr>
          <a:xfrm rot="16200000">
            <a:off x="9328913" y="4631383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0.2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EC742810-F1B7-3D09-2AAF-9578F6E14ACC}"/>
              </a:ext>
            </a:extLst>
          </p:cNvPr>
          <p:cNvSpPr txBox="1"/>
          <p:nvPr/>
        </p:nvSpPr>
        <p:spPr>
          <a:xfrm rot="16200000">
            <a:off x="9811364" y="4631383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0.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6F3A47E8-CE29-307A-D7AE-338139882DEF}"/>
              </a:ext>
            </a:extLst>
          </p:cNvPr>
          <p:cNvSpPr txBox="1"/>
          <p:nvPr/>
        </p:nvSpPr>
        <p:spPr>
          <a:xfrm rot="16200000">
            <a:off x="10157263" y="4767935"/>
            <a:ext cx="2105567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1.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E977DCE0-5C7E-13E8-A97E-A240436DD4F1}"/>
              </a:ext>
            </a:extLst>
          </p:cNvPr>
          <p:cNvSpPr txBox="1"/>
          <p:nvPr/>
        </p:nvSpPr>
        <p:spPr>
          <a:xfrm>
            <a:off x="2482351" y="1514715"/>
            <a:ext cx="6238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1st</a:t>
            </a:r>
            <a:endParaRPr lang="zh-CN" altLang="en-US" sz="28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67B0697E-1E75-4921-928C-3D9509762F28}"/>
              </a:ext>
            </a:extLst>
          </p:cNvPr>
          <p:cNvSpPr txBox="1"/>
          <p:nvPr/>
        </p:nvSpPr>
        <p:spPr>
          <a:xfrm>
            <a:off x="6103343" y="1514715"/>
            <a:ext cx="7649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2nd</a:t>
            </a:r>
            <a:endParaRPr lang="zh-CN" altLang="en-US" sz="28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55BA20B-CF6A-CFB5-C931-32D3264B649E}"/>
              </a:ext>
            </a:extLst>
          </p:cNvPr>
          <p:cNvSpPr txBox="1"/>
          <p:nvPr/>
        </p:nvSpPr>
        <p:spPr>
          <a:xfrm>
            <a:off x="9887171" y="1514715"/>
            <a:ext cx="7232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3rd</a:t>
            </a:r>
            <a:endParaRPr lang="zh-CN" altLang="en-US" sz="2800" dirty="0"/>
          </a:p>
        </p:txBody>
      </p:sp>
    </p:spTree>
    <p:extLst>
      <p:ext uri="{BB962C8B-B14F-4D97-AF65-F5344CB8AC3E}">
        <p14:creationId xmlns:p14="http://schemas.microsoft.com/office/powerpoint/2010/main" val="40576602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1C6C160-D243-C0E4-A13A-5E63CD83A1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253">
            <a:off x="2819246" y="850661"/>
            <a:ext cx="3118869" cy="3818427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1897FB18-3803-30CB-0863-EA7D33FD334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" b="12706"/>
          <a:stretch/>
        </p:blipFill>
        <p:spPr>
          <a:xfrm>
            <a:off x="7073599" y="1219199"/>
            <a:ext cx="2591279" cy="3190225"/>
          </a:xfrm>
          <a:prstGeom prst="rect">
            <a:avLst/>
          </a:prstGeom>
        </p:spPr>
      </p:pic>
      <p:sp>
        <p:nvSpPr>
          <p:cNvPr id="37" name="文本框 36">
            <a:extLst>
              <a:ext uri="{FF2B5EF4-FFF2-40B4-BE49-F238E27FC236}">
                <a16:creationId xmlns:a16="http://schemas.microsoft.com/office/drawing/2014/main" id="{8E03E5A3-656B-CCFD-2E03-F97F35622372}"/>
              </a:ext>
            </a:extLst>
          </p:cNvPr>
          <p:cNvSpPr txBox="1"/>
          <p:nvPr/>
        </p:nvSpPr>
        <p:spPr>
          <a:xfrm>
            <a:off x="1712591" y="2943120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E249387-2D46-3E0B-8C46-63DFE67FEE47}"/>
              </a:ext>
            </a:extLst>
          </p:cNvPr>
          <p:cNvSpPr txBox="1"/>
          <p:nvPr/>
        </p:nvSpPr>
        <p:spPr>
          <a:xfrm>
            <a:off x="5914510" y="3312452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27D213F1-AC84-79A4-6257-DB5D24CD001C}"/>
              </a:ext>
            </a:extLst>
          </p:cNvPr>
          <p:cNvSpPr txBox="1"/>
          <p:nvPr/>
        </p:nvSpPr>
        <p:spPr>
          <a:xfrm>
            <a:off x="323748" y="303194"/>
            <a:ext cx="254909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B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membrane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st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5" name="组合 64">
            <a:extLst>
              <a:ext uri="{FF2B5EF4-FFF2-40B4-BE49-F238E27FC236}">
                <a16:creationId xmlns:a16="http://schemas.microsoft.com/office/drawing/2014/main" id="{2B76F89C-FEFD-4C88-5FD1-B73F71A0F6EC}"/>
              </a:ext>
            </a:extLst>
          </p:cNvPr>
          <p:cNvGrpSpPr/>
          <p:nvPr/>
        </p:nvGrpSpPr>
        <p:grpSpPr>
          <a:xfrm>
            <a:off x="3291144" y="4576656"/>
            <a:ext cx="1988809" cy="2105567"/>
            <a:chOff x="3284217" y="4375765"/>
            <a:chExt cx="1988809" cy="2105567"/>
          </a:xfrm>
        </p:grpSpPr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FDBB362E-FDB9-719F-174A-3EF3DB22D98E}"/>
                </a:ext>
              </a:extLst>
            </p:cNvPr>
            <p:cNvSpPr txBox="1"/>
            <p:nvPr/>
          </p:nvSpPr>
          <p:spPr>
            <a:xfrm rot="16200000">
              <a:off x="2552651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822A8626-DF54-66BC-2500-2FDDF74CAE68}"/>
                </a:ext>
              </a:extLst>
            </p:cNvPr>
            <p:cNvSpPr txBox="1"/>
            <p:nvPr/>
          </p:nvSpPr>
          <p:spPr>
            <a:xfrm rot="16200000">
              <a:off x="2957520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GF-β1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A8576993-F6EB-A082-29C5-84AF8E0C8BA5}"/>
                </a:ext>
              </a:extLst>
            </p:cNvPr>
            <p:cNvSpPr txBox="1"/>
            <p:nvPr/>
          </p:nvSpPr>
          <p:spPr>
            <a:xfrm rot="16200000">
              <a:off x="3362389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37EEF614-655D-B88E-22AF-4EB28B1EBE29}"/>
                </a:ext>
              </a:extLst>
            </p:cNvPr>
            <p:cNvSpPr txBox="1"/>
            <p:nvPr/>
          </p:nvSpPr>
          <p:spPr>
            <a:xfrm rot="16200000">
              <a:off x="3767258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0F4BB675-59DA-6398-C882-9DBAB6B1058B}"/>
                </a:ext>
              </a:extLst>
            </p:cNvPr>
            <p:cNvSpPr txBox="1"/>
            <p:nvPr/>
          </p:nvSpPr>
          <p:spPr>
            <a:xfrm rot="16200000">
              <a:off x="4035576" y="5243883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.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6" name="组合 65">
            <a:extLst>
              <a:ext uri="{FF2B5EF4-FFF2-40B4-BE49-F238E27FC236}">
                <a16:creationId xmlns:a16="http://schemas.microsoft.com/office/drawing/2014/main" id="{BC374F75-DA87-3183-1E3D-B63C65811A1F}"/>
              </a:ext>
            </a:extLst>
          </p:cNvPr>
          <p:cNvGrpSpPr/>
          <p:nvPr/>
        </p:nvGrpSpPr>
        <p:grpSpPr>
          <a:xfrm>
            <a:off x="7339831" y="4576656"/>
            <a:ext cx="1988809" cy="2105567"/>
            <a:chOff x="3284217" y="4375765"/>
            <a:chExt cx="1988809" cy="2105567"/>
          </a:xfrm>
        </p:grpSpPr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E8AA0BB4-CD47-DA6E-FD69-767DAD735990}"/>
                </a:ext>
              </a:extLst>
            </p:cNvPr>
            <p:cNvSpPr txBox="1"/>
            <p:nvPr/>
          </p:nvSpPr>
          <p:spPr>
            <a:xfrm rot="16200000">
              <a:off x="2552651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054E3E54-C82B-A08C-969B-389791878099}"/>
                </a:ext>
              </a:extLst>
            </p:cNvPr>
            <p:cNvSpPr txBox="1"/>
            <p:nvPr/>
          </p:nvSpPr>
          <p:spPr>
            <a:xfrm rot="16200000">
              <a:off x="2957520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GF-β1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EA5FD36E-6FAD-FEE0-AC79-13C91402EDF9}"/>
                </a:ext>
              </a:extLst>
            </p:cNvPr>
            <p:cNvSpPr txBox="1"/>
            <p:nvPr/>
          </p:nvSpPr>
          <p:spPr>
            <a:xfrm rot="16200000">
              <a:off x="3362389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92885184-BF63-A4F1-1B95-5CED9E99E32E}"/>
                </a:ext>
              </a:extLst>
            </p:cNvPr>
            <p:cNvSpPr txBox="1"/>
            <p:nvPr/>
          </p:nvSpPr>
          <p:spPr>
            <a:xfrm rot="16200000">
              <a:off x="3767258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69C0C1E3-E932-6173-A9D1-AFE23367F013}"/>
                </a:ext>
              </a:extLst>
            </p:cNvPr>
            <p:cNvSpPr txBox="1"/>
            <p:nvPr/>
          </p:nvSpPr>
          <p:spPr>
            <a:xfrm rot="16200000">
              <a:off x="4035576" y="5243883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.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697301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>
            <a:extLst>
              <a:ext uri="{FF2B5EF4-FFF2-40B4-BE49-F238E27FC236}">
                <a16:creationId xmlns:a16="http://schemas.microsoft.com/office/drawing/2014/main" id="{39A17B94-FC13-3B52-DB3A-D75AA5F248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03342" y="870549"/>
            <a:ext cx="2720452" cy="357868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2151253E-6B7B-BCA3-2F8E-B131606860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06280" y="1098598"/>
            <a:ext cx="2636807" cy="3350640"/>
          </a:xfrm>
          <a:prstGeom prst="rect">
            <a:avLst/>
          </a:prstGeom>
        </p:spPr>
      </p:pic>
      <p:sp>
        <p:nvSpPr>
          <p:cNvPr id="37" name="文本框 36">
            <a:extLst>
              <a:ext uri="{FF2B5EF4-FFF2-40B4-BE49-F238E27FC236}">
                <a16:creationId xmlns:a16="http://schemas.microsoft.com/office/drawing/2014/main" id="{8E03E5A3-656B-CCFD-2E03-F97F35622372}"/>
              </a:ext>
            </a:extLst>
          </p:cNvPr>
          <p:cNvSpPr txBox="1"/>
          <p:nvPr/>
        </p:nvSpPr>
        <p:spPr>
          <a:xfrm>
            <a:off x="1591369" y="2846648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E249387-2D46-3E0B-8C46-63DFE67FEE47}"/>
              </a:ext>
            </a:extLst>
          </p:cNvPr>
          <p:cNvSpPr txBox="1"/>
          <p:nvPr/>
        </p:nvSpPr>
        <p:spPr>
          <a:xfrm>
            <a:off x="6036365" y="3391863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27D213F1-AC84-79A4-6257-DB5D24CD001C}"/>
              </a:ext>
            </a:extLst>
          </p:cNvPr>
          <p:cNvSpPr txBox="1"/>
          <p:nvPr/>
        </p:nvSpPr>
        <p:spPr>
          <a:xfrm>
            <a:off x="323748" y="303194"/>
            <a:ext cx="254909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B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membrane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nd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00D0CE70-F495-C19D-24CD-5A32FE1E437E}"/>
              </a:ext>
            </a:extLst>
          </p:cNvPr>
          <p:cNvGrpSpPr/>
          <p:nvPr/>
        </p:nvGrpSpPr>
        <p:grpSpPr>
          <a:xfrm>
            <a:off x="3121151" y="4449239"/>
            <a:ext cx="1988809" cy="2105567"/>
            <a:chOff x="3284217" y="4375765"/>
            <a:chExt cx="1988809" cy="2105567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808F2C33-4DEC-854F-00E0-CF6D3D7C2A1A}"/>
                </a:ext>
              </a:extLst>
            </p:cNvPr>
            <p:cNvSpPr txBox="1"/>
            <p:nvPr/>
          </p:nvSpPr>
          <p:spPr>
            <a:xfrm rot="16200000">
              <a:off x="2552651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2D2D86BD-3DE9-2B65-496E-825B531FC2BC}"/>
                </a:ext>
              </a:extLst>
            </p:cNvPr>
            <p:cNvSpPr txBox="1"/>
            <p:nvPr/>
          </p:nvSpPr>
          <p:spPr>
            <a:xfrm rot="16200000">
              <a:off x="2957520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GF-β1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1B541D6E-A1E6-7C95-3652-DBB2EB639F5E}"/>
                </a:ext>
              </a:extLst>
            </p:cNvPr>
            <p:cNvSpPr txBox="1"/>
            <p:nvPr/>
          </p:nvSpPr>
          <p:spPr>
            <a:xfrm rot="16200000">
              <a:off x="3362389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43C98D81-0E09-670E-8B75-4F431E53FB03}"/>
                </a:ext>
              </a:extLst>
            </p:cNvPr>
            <p:cNvSpPr txBox="1"/>
            <p:nvPr/>
          </p:nvSpPr>
          <p:spPr>
            <a:xfrm rot="16200000">
              <a:off x="3767258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1A978D70-A509-6880-65E6-96374ACCF7CF}"/>
                </a:ext>
              </a:extLst>
            </p:cNvPr>
            <p:cNvSpPr txBox="1"/>
            <p:nvPr/>
          </p:nvSpPr>
          <p:spPr>
            <a:xfrm rot="16200000">
              <a:off x="4035576" y="5243883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.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组合 8">
            <a:extLst>
              <a:ext uri="{FF2B5EF4-FFF2-40B4-BE49-F238E27FC236}">
                <a16:creationId xmlns:a16="http://schemas.microsoft.com/office/drawing/2014/main" id="{D2943FD4-C6C8-96E8-7D04-69843E862CB1}"/>
              </a:ext>
            </a:extLst>
          </p:cNvPr>
          <p:cNvGrpSpPr/>
          <p:nvPr/>
        </p:nvGrpSpPr>
        <p:grpSpPr>
          <a:xfrm>
            <a:off x="7714861" y="4449238"/>
            <a:ext cx="1988809" cy="2105567"/>
            <a:chOff x="3284217" y="4375765"/>
            <a:chExt cx="1988809" cy="2105567"/>
          </a:xfrm>
        </p:grpSpPr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C69714FC-2425-8A95-E4DF-71DA014A91A2}"/>
                </a:ext>
              </a:extLst>
            </p:cNvPr>
            <p:cNvSpPr txBox="1"/>
            <p:nvPr/>
          </p:nvSpPr>
          <p:spPr>
            <a:xfrm rot="16200000">
              <a:off x="2552651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1E64AE16-86DA-DAE2-F0D5-662B375AAE24}"/>
                </a:ext>
              </a:extLst>
            </p:cNvPr>
            <p:cNvSpPr txBox="1"/>
            <p:nvPr/>
          </p:nvSpPr>
          <p:spPr>
            <a:xfrm rot="16200000">
              <a:off x="2957520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GF-β1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537F55B1-D2B5-C69E-5920-B875186CF493}"/>
                </a:ext>
              </a:extLst>
            </p:cNvPr>
            <p:cNvSpPr txBox="1"/>
            <p:nvPr/>
          </p:nvSpPr>
          <p:spPr>
            <a:xfrm rot="16200000">
              <a:off x="3362389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A1AA80C3-2085-AE42-B405-4F4DC1ABBC96}"/>
                </a:ext>
              </a:extLst>
            </p:cNvPr>
            <p:cNvSpPr txBox="1"/>
            <p:nvPr/>
          </p:nvSpPr>
          <p:spPr>
            <a:xfrm rot="16200000">
              <a:off x="3767258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7DAEB9B2-3B49-50E9-619D-839E3753870B}"/>
                </a:ext>
              </a:extLst>
            </p:cNvPr>
            <p:cNvSpPr txBox="1"/>
            <p:nvPr/>
          </p:nvSpPr>
          <p:spPr>
            <a:xfrm rot="16200000">
              <a:off x="4035576" y="5243883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.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067170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图片 19">
            <a:extLst>
              <a:ext uri="{FF2B5EF4-FFF2-40B4-BE49-F238E27FC236}">
                <a16:creationId xmlns:a16="http://schemas.microsoft.com/office/drawing/2014/main" id="{064CA7C8-A304-6216-736A-F5BFD2F46C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361460">
            <a:off x="7510619" y="951784"/>
            <a:ext cx="2306112" cy="3242256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BE8F0482-5220-9B6C-A5A3-8CEA37EF8DC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47436" y="995692"/>
            <a:ext cx="2601310" cy="3536868"/>
          </a:xfrm>
          <a:prstGeom prst="rect">
            <a:avLst/>
          </a:prstGeom>
        </p:spPr>
      </p:pic>
      <p:sp>
        <p:nvSpPr>
          <p:cNvPr id="37" name="文本框 36">
            <a:extLst>
              <a:ext uri="{FF2B5EF4-FFF2-40B4-BE49-F238E27FC236}">
                <a16:creationId xmlns:a16="http://schemas.microsoft.com/office/drawing/2014/main" id="{8E03E5A3-656B-CCFD-2E03-F97F35622372}"/>
              </a:ext>
            </a:extLst>
          </p:cNvPr>
          <p:cNvSpPr txBox="1"/>
          <p:nvPr/>
        </p:nvSpPr>
        <p:spPr>
          <a:xfrm>
            <a:off x="1598296" y="2572912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E249387-2D46-3E0B-8C46-63DFE67FEE47}"/>
              </a:ext>
            </a:extLst>
          </p:cNvPr>
          <p:cNvSpPr txBox="1"/>
          <p:nvPr/>
        </p:nvSpPr>
        <p:spPr>
          <a:xfrm>
            <a:off x="6096000" y="3059668"/>
            <a:ext cx="151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27D213F1-AC84-79A4-6257-DB5D24CD001C}"/>
              </a:ext>
            </a:extLst>
          </p:cNvPr>
          <p:cNvSpPr txBox="1"/>
          <p:nvPr/>
        </p:nvSpPr>
        <p:spPr>
          <a:xfrm>
            <a:off x="323748" y="303194"/>
            <a:ext cx="254909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B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membrane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rd</a:t>
            </a: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0E585AC6-0B22-0564-8507-14126BD0D1E5}"/>
              </a:ext>
            </a:extLst>
          </p:cNvPr>
          <p:cNvGrpSpPr/>
          <p:nvPr/>
        </p:nvGrpSpPr>
        <p:grpSpPr>
          <a:xfrm>
            <a:off x="3253686" y="4583584"/>
            <a:ext cx="1988809" cy="2105567"/>
            <a:chOff x="3284217" y="4375765"/>
            <a:chExt cx="1988809" cy="2105567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493F93F9-134F-159F-49C3-6BB5FAC90421}"/>
                </a:ext>
              </a:extLst>
            </p:cNvPr>
            <p:cNvSpPr txBox="1"/>
            <p:nvPr/>
          </p:nvSpPr>
          <p:spPr>
            <a:xfrm rot="16200000">
              <a:off x="2552651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C0EC139D-2CD5-A4AD-8CB7-01BC379FB778}"/>
                </a:ext>
              </a:extLst>
            </p:cNvPr>
            <p:cNvSpPr txBox="1"/>
            <p:nvPr/>
          </p:nvSpPr>
          <p:spPr>
            <a:xfrm rot="16200000">
              <a:off x="2957520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GF-β1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EA6C90A1-A618-89B7-A7A7-A3F9FA3F8616}"/>
                </a:ext>
              </a:extLst>
            </p:cNvPr>
            <p:cNvSpPr txBox="1"/>
            <p:nvPr/>
          </p:nvSpPr>
          <p:spPr>
            <a:xfrm rot="16200000">
              <a:off x="3362389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3B2F9B35-51DC-EB3D-1DB0-9BC8C61C9BE5}"/>
                </a:ext>
              </a:extLst>
            </p:cNvPr>
            <p:cNvSpPr txBox="1"/>
            <p:nvPr/>
          </p:nvSpPr>
          <p:spPr>
            <a:xfrm rot="16200000">
              <a:off x="3767258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E54E3BDC-4614-8E9D-D085-0609B554079A}"/>
                </a:ext>
              </a:extLst>
            </p:cNvPr>
            <p:cNvSpPr txBox="1"/>
            <p:nvPr/>
          </p:nvSpPr>
          <p:spPr>
            <a:xfrm rot="16200000">
              <a:off x="4035576" y="5243883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.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组合 8">
            <a:extLst>
              <a:ext uri="{FF2B5EF4-FFF2-40B4-BE49-F238E27FC236}">
                <a16:creationId xmlns:a16="http://schemas.microsoft.com/office/drawing/2014/main" id="{7C19F16C-B484-E015-9BEA-CBC01C51CD28}"/>
              </a:ext>
            </a:extLst>
          </p:cNvPr>
          <p:cNvGrpSpPr/>
          <p:nvPr/>
        </p:nvGrpSpPr>
        <p:grpSpPr>
          <a:xfrm>
            <a:off x="7690387" y="4583585"/>
            <a:ext cx="1988809" cy="2105567"/>
            <a:chOff x="3284217" y="4375765"/>
            <a:chExt cx="1988809" cy="2105567"/>
          </a:xfrm>
        </p:grpSpPr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5BF084FD-4670-0EF0-F62A-08AE57AAE08E}"/>
                </a:ext>
              </a:extLst>
            </p:cNvPr>
            <p:cNvSpPr txBox="1"/>
            <p:nvPr/>
          </p:nvSpPr>
          <p:spPr>
            <a:xfrm rot="16200000">
              <a:off x="2552651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99E0D95F-64F2-F75C-B39C-0C752E70363E}"/>
                </a:ext>
              </a:extLst>
            </p:cNvPr>
            <p:cNvSpPr txBox="1"/>
            <p:nvPr/>
          </p:nvSpPr>
          <p:spPr>
            <a:xfrm rot="16200000">
              <a:off x="2957520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GF-β1</a:t>
              </a:r>
              <a:endParaRPr lang="zh-CN" altLang="en-US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FAA7FF9E-47C3-1F53-0CFF-92E15A6BFF3B}"/>
                </a:ext>
              </a:extLst>
            </p:cNvPr>
            <p:cNvSpPr txBox="1"/>
            <p:nvPr/>
          </p:nvSpPr>
          <p:spPr>
            <a:xfrm rot="16200000">
              <a:off x="3362389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2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1CF284A6-7817-31F6-1658-EE85E8F9B5AD}"/>
                </a:ext>
              </a:extLst>
            </p:cNvPr>
            <p:cNvSpPr txBox="1"/>
            <p:nvPr/>
          </p:nvSpPr>
          <p:spPr>
            <a:xfrm rot="16200000">
              <a:off x="3767258" y="5107332"/>
              <a:ext cx="1832464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0.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34542511-7E9A-7E02-EE3A-13667AE39C7B}"/>
                </a:ext>
              </a:extLst>
            </p:cNvPr>
            <p:cNvSpPr txBox="1"/>
            <p:nvPr/>
          </p:nvSpPr>
          <p:spPr>
            <a:xfrm rot="16200000">
              <a:off x="4035576" y="5243883"/>
              <a:ext cx="2105567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HWE-1.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873732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8BDB75DF-A183-E5EE-6380-445BDA041B24}"/>
              </a:ext>
            </a:extLst>
          </p:cNvPr>
          <p:cNvSpPr txBox="1"/>
          <p:nvPr/>
        </p:nvSpPr>
        <p:spPr>
          <a:xfrm>
            <a:off x="323748" y="303194"/>
            <a:ext cx="3281604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A</a:t>
            </a:r>
          </a:p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opped membrane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0CED8E55-5273-5AD4-D5F2-DA151FC39F28}"/>
              </a:ext>
            </a:extLst>
          </p:cNvPr>
          <p:cNvSpPr txBox="1"/>
          <p:nvPr/>
        </p:nvSpPr>
        <p:spPr>
          <a:xfrm>
            <a:off x="2572403" y="1514715"/>
            <a:ext cx="6238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1st</a:t>
            </a:r>
            <a:endParaRPr lang="zh-CN" altLang="en-US" sz="2800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47AACE22-CBA7-A6F7-8280-1C456C094193}"/>
              </a:ext>
            </a:extLst>
          </p:cNvPr>
          <p:cNvSpPr txBox="1"/>
          <p:nvPr/>
        </p:nvSpPr>
        <p:spPr>
          <a:xfrm>
            <a:off x="6158757" y="1514715"/>
            <a:ext cx="7649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2nd</a:t>
            </a:r>
            <a:endParaRPr lang="zh-CN" altLang="en-US" sz="2800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54A947F-7EC5-99BE-889F-44B10BAC4881}"/>
              </a:ext>
            </a:extLst>
          </p:cNvPr>
          <p:cNvSpPr txBox="1"/>
          <p:nvPr/>
        </p:nvSpPr>
        <p:spPr>
          <a:xfrm>
            <a:off x="9838678" y="1514715"/>
            <a:ext cx="7232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2800" dirty="0"/>
              <a:t>3rd</a:t>
            </a:r>
            <a:endParaRPr lang="zh-CN" altLang="en-US" sz="2800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15913953-8A4E-0F4E-39EC-C5E40F43ACD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723" t="21026" r="10639" b="20736"/>
          <a:stretch/>
        </p:blipFill>
        <p:spPr>
          <a:xfrm>
            <a:off x="1382653" y="2026186"/>
            <a:ext cx="2933683" cy="55371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FE4316B5-2279-E1D8-BF82-011779E322A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921" t="10197" r="11351" b="40141"/>
          <a:stretch/>
        </p:blipFill>
        <p:spPr>
          <a:xfrm>
            <a:off x="1382652" y="2763130"/>
            <a:ext cx="2933683" cy="513657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2B079203-4E56-BCE2-AA16-1501DB52EE6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523" t="7027" r="6144" b="12130"/>
          <a:stretch/>
        </p:blipFill>
        <p:spPr>
          <a:xfrm>
            <a:off x="1382652" y="3429000"/>
            <a:ext cx="2995970" cy="446639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706CF973-15ED-BFE9-9748-71706313592F}"/>
              </a:ext>
            </a:extLst>
          </p:cNvPr>
          <p:cNvSpPr txBox="1"/>
          <p:nvPr/>
        </p:nvSpPr>
        <p:spPr>
          <a:xfrm>
            <a:off x="38024" y="3476026"/>
            <a:ext cx="1520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AF6AC84-5BBD-9C6E-5462-A3D955571222}"/>
              </a:ext>
            </a:extLst>
          </p:cNvPr>
          <p:cNvSpPr txBox="1"/>
          <p:nvPr/>
        </p:nvSpPr>
        <p:spPr>
          <a:xfrm>
            <a:off x="0" y="2835950"/>
            <a:ext cx="1558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BEA11C9-F6CF-416A-6A36-BC2944E75A63}"/>
              </a:ext>
            </a:extLst>
          </p:cNvPr>
          <p:cNvSpPr txBox="1"/>
          <p:nvPr/>
        </p:nvSpPr>
        <p:spPr>
          <a:xfrm>
            <a:off x="-14221" y="2146580"/>
            <a:ext cx="1558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STA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A427A30-7844-56E6-AC6C-8A84A4A69051}"/>
              </a:ext>
            </a:extLst>
          </p:cNvPr>
          <p:cNvSpPr txBox="1"/>
          <p:nvPr/>
        </p:nvSpPr>
        <p:spPr>
          <a:xfrm rot="16200000">
            <a:off x="961236" y="4723383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4B692C9-5CEC-6C38-FB9E-ACE58B3D8E81}"/>
              </a:ext>
            </a:extLst>
          </p:cNvPr>
          <p:cNvSpPr txBox="1"/>
          <p:nvPr/>
        </p:nvSpPr>
        <p:spPr>
          <a:xfrm rot="16200000">
            <a:off x="1451735" y="4723383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lang="zh-CN" alt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3B89B1B-A5B3-9C66-5F11-7CC607FB88A0}"/>
              </a:ext>
            </a:extLst>
          </p:cNvPr>
          <p:cNvSpPr txBox="1"/>
          <p:nvPr/>
        </p:nvSpPr>
        <p:spPr>
          <a:xfrm rot="16200000">
            <a:off x="1942235" y="4723383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0.2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832A881-AB11-04BE-E48C-CD67F1C6E694}"/>
              </a:ext>
            </a:extLst>
          </p:cNvPr>
          <p:cNvSpPr txBox="1"/>
          <p:nvPr/>
        </p:nvSpPr>
        <p:spPr>
          <a:xfrm rot="16200000">
            <a:off x="2432735" y="4723383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0.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937F145-188A-F41E-1722-46FAF7D8EA34}"/>
              </a:ext>
            </a:extLst>
          </p:cNvPr>
          <p:cNvSpPr txBox="1"/>
          <p:nvPr/>
        </p:nvSpPr>
        <p:spPr>
          <a:xfrm rot="16200000">
            <a:off x="2786682" y="4859935"/>
            <a:ext cx="2105567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1.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0F3E834A-1D4A-6FA5-5197-A025C0BB078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90256" y="2706157"/>
            <a:ext cx="2933683" cy="692158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C6ACD10C-1F01-94EB-66ED-DD903B70363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01193" y="3455979"/>
            <a:ext cx="3122746" cy="594544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8575DC8C-9642-0256-CCA7-111439B5E69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90256" y="1956335"/>
            <a:ext cx="2903028" cy="749822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D128EDCC-63DD-9E1E-9C3F-65747634B30D}"/>
              </a:ext>
            </a:extLst>
          </p:cNvPr>
          <p:cNvSpPr txBox="1"/>
          <p:nvPr/>
        </p:nvSpPr>
        <p:spPr>
          <a:xfrm rot="16200000">
            <a:off x="4660126" y="4723383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09D82323-DCBD-5404-8659-B61125161D72}"/>
              </a:ext>
            </a:extLst>
          </p:cNvPr>
          <p:cNvSpPr txBox="1"/>
          <p:nvPr/>
        </p:nvSpPr>
        <p:spPr>
          <a:xfrm rot="16200000">
            <a:off x="5150625" y="4723383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lang="zh-CN" alt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5448376-DAEF-9F52-950A-8A4280CA1C67}"/>
              </a:ext>
            </a:extLst>
          </p:cNvPr>
          <p:cNvSpPr txBox="1"/>
          <p:nvPr/>
        </p:nvSpPr>
        <p:spPr>
          <a:xfrm rot="16200000">
            <a:off x="5641125" y="4723383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0.2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39D74191-D589-0C92-F7D5-1FDCD1C9FD31}"/>
              </a:ext>
            </a:extLst>
          </p:cNvPr>
          <p:cNvSpPr txBox="1"/>
          <p:nvPr/>
        </p:nvSpPr>
        <p:spPr>
          <a:xfrm rot="16200000">
            <a:off x="6131625" y="4723383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0.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AC2E1B8-FF34-4ED9-4378-D38D238B6C23}"/>
              </a:ext>
            </a:extLst>
          </p:cNvPr>
          <p:cNvSpPr txBox="1"/>
          <p:nvPr/>
        </p:nvSpPr>
        <p:spPr>
          <a:xfrm rot="16200000">
            <a:off x="6485572" y="4859935"/>
            <a:ext cx="2105567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1.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1448DD36-2A79-C79A-3C8A-452D4D358E9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767204" y="1937286"/>
            <a:ext cx="2903028" cy="491600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F3A61DDA-C652-A8A3-CCA8-77793A0E159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846407" y="2440275"/>
            <a:ext cx="2744622" cy="918931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F5F91258-6C3D-8CBB-0D37-B46A7B9F6B3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470218" y="3367126"/>
            <a:ext cx="3200014" cy="554251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78AB2C89-A4BC-3D40-9173-9BCDA5DE234A}"/>
              </a:ext>
            </a:extLst>
          </p:cNvPr>
          <p:cNvSpPr txBox="1"/>
          <p:nvPr/>
        </p:nvSpPr>
        <p:spPr>
          <a:xfrm rot="16200000">
            <a:off x="8114841" y="4723384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FB86A2AD-E5F5-0760-F33E-010B2EA792CD}"/>
              </a:ext>
            </a:extLst>
          </p:cNvPr>
          <p:cNvSpPr txBox="1"/>
          <p:nvPr/>
        </p:nvSpPr>
        <p:spPr>
          <a:xfrm rot="16200000">
            <a:off x="8605340" y="4723384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lang="zh-CN" alt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4BF6A831-58E5-F212-C06D-AB67543008C4}"/>
              </a:ext>
            </a:extLst>
          </p:cNvPr>
          <p:cNvSpPr txBox="1"/>
          <p:nvPr/>
        </p:nvSpPr>
        <p:spPr>
          <a:xfrm rot="16200000">
            <a:off x="9095840" y="4723384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0.2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76372707-86AA-4B2A-06DF-95C86C0FB6EE}"/>
              </a:ext>
            </a:extLst>
          </p:cNvPr>
          <p:cNvSpPr txBox="1"/>
          <p:nvPr/>
        </p:nvSpPr>
        <p:spPr>
          <a:xfrm rot="16200000">
            <a:off x="9586340" y="4723384"/>
            <a:ext cx="183246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0.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90EB221E-0B3B-70D9-4218-33FF032A11E7}"/>
              </a:ext>
            </a:extLst>
          </p:cNvPr>
          <p:cNvSpPr txBox="1"/>
          <p:nvPr/>
        </p:nvSpPr>
        <p:spPr>
          <a:xfrm rot="16200000">
            <a:off x="9940287" y="4859936"/>
            <a:ext cx="2105567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HWE-1.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19639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51</TotalTime>
  <Words>697</Words>
  <Application>Microsoft Office PowerPoint</Application>
  <PresentationFormat>宽屏</PresentationFormat>
  <Paragraphs>403</Paragraphs>
  <Slides>2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2</vt:i4>
      </vt:variant>
    </vt:vector>
  </HeadingPairs>
  <TitlesOfParts>
    <vt:vector size="2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u Minmin</dc:creator>
  <cp:lastModifiedBy>安琳</cp:lastModifiedBy>
  <cp:revision>56</cp:revision>
  <dcterms:created xsi:type="dcterms:W3CDTF">2022-04-13T19:07:24Z</dcterms:created>
  <dcterms:modified xsi:type="dcterms:W3CDTF">2022-09-13T07:36:03Z</dcterms:modified>
</cp:coreProperties>
</file>